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1.xml" ContentType="application/vnd.openxmlformats-officedocument.themeOverrid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2.xml" ContentType="application/vnd.openxmlformats-officedocument.themeOverride+xml"/>
  <Override PartName="/ppt/drawings/drawing5.xml" ContentType="application/vnd.openxmlformats-officedocument.drawingml.chartshapes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drawings/drawing6.xml" ContentType="application/vnd.openxmlformats-officedocument.drawingml.chartshapes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theme/themeOverride3.xml" ContentType="application/vnd.openxmlformats-officedocument.themeOverrid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theme/themeOverride4.xml" ContentType="application/vnd.openxmlformats-officedocument.themeOverrid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theme/themeOverride5.xml" ContentType="application/vnd.openxmlformats-officedocument.themeOverrid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theme/themeOverride6.xml" ContentType="application/vnd.openxmlformats-officedocument.themeOverride+xml"/>
  <Override PartName="/ppt/drawings/drawing7.xml" ContentType="application/vnd.openxmlformats-officedocument.drawingml.chartshapes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drawings/drawing8.xml" ContentType="application/vnd.openxmlformats-officedocument.drawingml.chartshapes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drawings/drawing9.xml" ContentType="application/vnd.openxmlformats-officedocument.drawingml.chartshapes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4" r:id="rId3"/>
    <p:sldId id="257" r:id="rId4"/>
    <p:sldId id="263" r:id="rId5"/>
    <p:sldId id="262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86" d="100"/>
          <a:sy n="86" d="100"/>
        </p:scale>
        <p:origin x="42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8.xlsx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11.xml"/><Relationship Id="rId1" Type="http://schemas.microsoft.com/office/2011/relationships/chartStyle" Target="style11.xml"/><Relationship Id="rId4" Type="http://schemas.openxmlformats.org/officeDocument/2006/relationships/package" Target="../embeddings/Microsoft_Excel_Worksheet9.xlsx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12.xml"/><Relationship Id="rId1" Type="http://schemas.microsoft.com/office/2011/relationships/chartStyle" Target="style12.xml"/><Relationship Id="rId5" Type="http://schemas.openxmlformats.org/officeDocument/2006/relationships/chartUserShapes" Target="../drawings/drawing7.xml"/><Relationship Id="rId4" Type="http://schemas.openxmlformats.org/officeDocument/2006/relationships/package" Target="../embeddings/Microsoft_Excel_Worksheet10.xlsx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1.xlsx"/><Relationship Id="rId2" Type="http://schemas.microsoft.com/office/2011/relationships/chartColorStyle" Target="colors13.xml"/><Relationship Id="rId1" Type="http://schemas.microsoft.com/office/2011/relationships/chartStyle" Target="style13.xml"/><Relationship Id="rId4" Type="http://schemas.openxmlformats.org/officeDocument/2006/relationships/chartUserShapes" Target="../drawings/drawing8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2.xlsx"/><Relationship Id="rId2" Type="http://schemas.microsoft.com/office/2011/relationships/chartColorStyle" Target="colors14.xml"/><Relationship Id="rId1" Type="http://schemas.microsoft.com/office/2011/relationships/chartStyle" Target="style14.xml"/><Relationship Id="rId4" Type="http://schemas.openxmlformats.org/officeDocument/2006/relationships/chartUserShapes" Target="../drawings/drawing9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3.xlsx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2.xml"/><Relationship Id="rId1" Type="http://schemas.microsoft.com/office/2011/relationships/chartStyle" Target="style2.xml"/><Relationship Id="rId5" Type="http://schemas.openxmlformats.org/officeDocument/2006/relationships/chartUserShapes" Target="../drawings/drawing2.xml"/><Relationship Id="rId4" Type="http://schemas.openxmlformats.org/officeDocument/2006/relationships/oleObject" Target="../embeddings/oleObject1.bin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chartUserShapes" Target="../drawings/drawing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5.xml"/><Relationship Id="rId1" Type="http://schemas.microsoft.com/office/2011/relationships/chartStyle" Target="style5.xml"/><Relationship Id="rId5" Type="http://schemas.openxmlformats.org/officeDocument/2006/relationships/chartUserShapes" Target="../drawings/drawing5.xml"/><Relationship Id="rId4" Type="http://schemas.openxmlformats.org/officeDocument/2006/relationships/package" Target="../embeddings/Microsoft_Excel_Worksheet3.xlsx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chartUserShapes" Target="../drawings/drawing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package" Target="../embeddings/Microsoft_Excel_Worksheet5.xlsx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8.xml"/><Relationship Id="rId1" Type="http://schemas.microsoft.com/office/2011/relationships/chartStyle" Target="style8.xml"/><Relationship Id="rId4" Type="http://schemas.openxmlformats.org/officeDocument/2006/relationships/package" Target="../embeddings/Microsoft_Excel_Worksheet6.xlsx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000" b="1" i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bMFDX1</a:t>
            </a:r>
            <a:r>
              <a:rPr lang="en-US" sz="1000" b="1" i="1" baseline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/ ACT1</a:t>
            </a:r>
            <a:endParaRPr lang="en-US" sz="1000" b="1" i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8807602111592676"/>
          <c:y val="5.507514413825880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7025505365487867"/>
          <c:y val="0.23197049959959451"/>
          <c:w val="0.58907654139592125"/>
          <c:h val="0.5639196884228364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benth_vigs_mdx1_mdx2oldcdna!$Q$28:$Q$29</c:f>
                <c:numCache>
                  <c:formatCode>General</c:formatCode>
                  <c:ptCount val="2"/>
                  <c:pt idx="0">
                    <c:v>0.11929437458190884</c:v>
                  </c:pt>
                  <c:pt idx="1">
                    <c:v>0.1119270256898505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benth_vigs_mdx1_mdx2oldcdna!$O$28:$O$29</c:f>
              <c:strCache>
                <c:ptCount val="2"/>
                <c:pt idx="0">
                  <c:v>TRV2:GFP</c:v>
                </c:pt>
                <c:pt idx="1">
                  <c:v>TRV2:NbMFDX1</c:v>
                </c:pt>
              </c:strCache>
            </c:strRef>
          </c:cat>
          <c:val>
            <c:numRef>
              <c:f>benth_vigs_mdx1_mdx2oldcdna!$P$28:$P$29</c:f>
              <c:numCache>
                <c:formatCode>General</c:formatCode>
                <c:ptCount val="2"/>
                <c:pt idx="0">
                  <c:v>2.9577302963560692</c:v>
                </c:pt>
                <c:pt idx="1">
                  <c:v>0.65616727425035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02B-4A42-9990-3FFBFD76B6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3"/>
        <c:overlap val="-6"/>
        <c:axId val="451780016"/>
        <c:axId val="451785264"/>
      </c:barChart>
      <c:catAx>
        <c:axId val="4517800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51785264"/>
        <c:crosses val="autoZero"/>
        <c:auto val="1"/>
        <c:lblAlgn val="ctr"/>
        <c:lblOffset val="100"/>
        <c:noMultiLvlLbl val="0"/>
      </c:catAx>
      <c:valAx>
        <c:axId val="45178526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 expression (Log</a:t>
                </a:r>
                <a:r>
                  <a:rPr lang="en-US" b="1" baseline="-2500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c:rich>
          </c:tx>
          <c:layout>
            <c:manualLayout>
              <c:xMode val="edge"/>
              <c:yMode val="edge"/>
              <c:x val="9.8749666112024626E-2"/>
              <c:y val="5.800490309096640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51780016"/>
        <c:crosses val="autoZero"/>
        <c:crossBetween val="between"/>
        <c:min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0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xalat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50856125028729"/>
          <c:y val="0.19009006144888568"/>
          <c:w val="0.6186957739600093"/>
          <c:h val="0.533108823115317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oxalate!$K$5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oxalate!$O$5:$Q$5</c:f>
                <c:numCache>
                  <c:formatCode>General</c:formatCode>
                  <c:ptCount val="3"/>
                  <c:pt idx="0">
                    <c:v>3.9704470781009062E-2</c:v>
                  </c:pt>
                  <c:pt idx="1">
                    <c:v>7.7931989580659597E-2</c:v>
                  </c:pt>
                  <c:pt idx="2">
                    <c:v>3.587599011409504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oxalate!$R$19:$R$21</c:f>
              <c:strCache>
                <c:ptCount val="3"/>
                <c:pt idx="0">
                  <c:v>0 hpi</c:v>
                </c:pt>
                <c:pt idx="1">
                  <c:v>1 dpi</c:v>
                </c:pt>
                <c:pt idx="2">
                  <c:v>3 dpi</c:v>
                </c:pt>
              </c:strCache>
            </c:strRef>
          </c:cat>
          <c:val>
            <c:numRef>
              <c:f>oxalate!$L$5:$N$5</c:f>
              <c:numCache>
                <c:formatCode>General</c:formatCode>
                <c:ptCount val="3"/>
                <c:pt idx="0">
                  <c:v>0.64059999999999995</c:v>
                </c:pt>
                <c:pt idx="1">
                  <c:v>0.60670000000000002</c:v>
                </c:pt>
                <c:pt idx="2">
                  <c:v>0.3520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A37-4D04-A463-AF5D6F5A16B2}"/>
            </c:ext>
          </c:extLst>
        </c:ser>
        <c:ser>
          <c:idx val="1"/>
          <c:order val="1"/>
          <c:tx>
            <c:strRef>
              <c:f>oxalate!$K$8</c:f>
              <c:strCache>
                <c:ptCount val="1"/>
                <c:pt idx="0">
                  <c:v>mfdx1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oxalate!$O$8:$Q$8</c:f>
                <c:numCache>
                  <c:formatCode>General</c:formatCode>
                  <c:ptCount val="3"/>
                  <c:pt idx="0">
                    <c:v>3.6037781100765186E-2</c:v>
                  </c:pt>
                  <c:pt idx="1">
                    <c:v>0.15903925616023226</c:v>
                  </c:pt>
                  <c:pt idx="2">
                    <c:v>2.904310015591769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oxalate!$R$19:$R$21</c:f>
              <c:strCache>
                <c:ptCount val="3"/>
                <c:pt idx="0">
                  <c:v>0 hpi</c:v>
                </c:pt>
                <c:pt idx="1">
                  <c:v>1 dpi</c:v>
                </c:pt>
                <c:pt idx="2">
                  <c:v>3 dpi</c:v>
                </c:pt>
              </c:strCache>
            </c:strRef>
          </c:cat>
          <c:val>
            <c:numRef>
              <c:f>oxalate!$L$8:$N$8</c:f>
              <c:numCache>
                <c:formatCode>General</c:formatCode>
                <c:ptCount val="3"/>
                <c:pt idx="0">
                  <c:v>0.68723333333333336</c:v>
                </c:pt>
                <c:pt idx="1">
                  <c:v>0.50400000000000011</c:v>
                </c:pt>
                <c:pt idx="2">
                  <c:v>0.4449333333333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A37-4D04-A463-AF5D6F5A16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02857152"/>
        <c:axId val="502857480"/>
      </c:barChart>
      <c:catAx>
        <c:axId val="5028571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02857480"/>
        <c:crosses val="autoZero"/>
        <c:auto val="1"/>
        <c:lblAlgn val="ctr"/>
        <c:lblOffset val="100"/>
        <c:noMultiLvlLbl val="0"/>
      </c:catAx>
      <c:valAx>
        <c:axId val="5028574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028571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0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osphat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56272965879265"/>
          <c:y val="0.16708333333333336"/>
          <c:w val="0.6965949256342957"/>
          <c:h val="0.6117362933799941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hosphate!$J$5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rgbClr val="5B9BD5">
                <a:lumMod val="60000"/>
                <a:lumOff val="40000"/>
              </a:srgb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hosphate!$N$5:$P$5</c:f>
                <c:numCache>
                  <c:formatCode>General</c:formatCode>
                  <c:ptCount val="3"/>
                  <c:pt idx="0">
                    <c:v>0.98118636439091378</c:v>
                  </c:pt>
                  <c:pt idx="1">
                    <c:v>1.5679565236319513</c:v>
                  </c:pt>
                  <c:pt idx="2">
                    <c:v>0.9707341568798950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hosphate!$R$17:$R$19</c:f>
              <c:strCache>
                <c:ptCount val="3"/>
                <c:pt idx="0">
                  <c:v>0 hpi</c:v>
                </c:pt>
                <c:pt idx="1">
                  <c:v>1 dpi</c:v>
                </c:pt>
                <c:pt idx="2">
                  <c:v>3 dpi</c:v>
                </c:pt>
              </c:strCache>
            </c:strRef>
          </c:cat>
          <c:val>
            <c:numRef>
              <c:f>phosphate!$K$5:$M$5</c:f>
              <c:numCache>
                <c:formatCode>General</c:formatCode>
                <c:ptCount val="3"/>
                <c:pt idx="0">
                  <c:v>7.6497333333333337</c:v>
                </c:pt>
                <c:pt idx="1">
                  <c:v>10.993400000000001</c:v>
                </c:pt>
                <c:pt idx="2">
                  <c:v>8.8475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D07-411C-BE8E-D5C694CBE425}"/>
            </c:ext>
          </c:extLst>
        </c:ser>
        <c:ser>
          <c:idx val="1"/>
          <c:order val="1"/>
          <c:tx>
            <c:strRef>
              <c:f>phosphate!$J$8</c:f>
              <c:strCache>
                <c:ptCount val="1"/>
                <c:pt idx="0">
                  <c:v>mfdx1</c:v>
                </c:pt>
              </c:strCache>
            </c:strRef>
          </c:tx>
          <c:spPr>
            <a:solidFill>
              <a:srgbClr val="70AD47">
                <a:lumMod val="60000"/>
                <a:lumOff val="40000"/>
              </a:srgb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hosphate!$N$8:$P$8</c:f>
                <c:numCache>
                  <c:formatCode>General</c:formatCode>
                  <c:ptCount val="3"/>
                  <c:pt idx="0">
                    <c:v>0.42127122696270924</c:v>
                  </c:pt>
                  <c:pt idx="1">
                    <c:v>0.81399283268752831</c:v>
                  </c:pt>
                  <c:pt idx="2">
                    <c:v>0.39492887967328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hosphate!$R$17:$R$19</c:f>
              <c:strCache>
                <c:ptCount val="3"/>
                <c:pt idx="0">
                  <c:v>0 hpi</c:v>
                </c:pt>
                <c:pt idx="1">
                  <c:v>1 dpi</c:v>
                </c:pt>
                <c:pt idx="2">
                  <c:v>3 dpi</c:v>
                </c:pt>
              </c:strCache>
            </c:strRef>
          </c:cat>
          <c:val>
            <c:numRef>
              <c:f>phosphate!$K$8:$M$8</c:f>
              <c:numCache>
                <c:formatCode>General</c:formatCode>
                <c:ptCount val="3"/>
                <c:pt idx="0">
                  <c:v>8.6146666666666665</c:v>
                </c:pt>
                <c:pt idx="1">
                  <c:v>9.9805333333333337</c:v>
                </c:pt>
                <c:pt idx="2">
                  <c:v>7.9767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D07-411C-BE8E-D5C694CBE4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02829928"/>
        <c:axId val="502832224"/>
      </c:barChart>
      <c:catAx>
        <c:axId val="5028299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02832224"/>
        <c:crosses val="autoZero"/>
        <c:auto val="1"/>
        <c:lblAlgn val="ctr"/>
        <c:lblOffset val="100"/>
        <c:noMultiLvlLbl val="0"/>
      </c:catAx>
      <c:valAx>
        <c:axId val="5028322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028299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0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onium</a:t>
            </a:r>
            <a:endParaRPr lang="en-US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8121981627296588"/>
          <c:y val="0.17634259259259263"/>
          <c:w val="0.67155796150481184"/>
          <c:h val="0.610354695246427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cat. amonium'!$H$4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rgbClr val="5B9BD5">
                <a:lumMod val="60000"/>
                <a:lumOff val="40000"/>
              </a:srgb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at. amonium'!$L$4:$N$4</c:f>
                <c:numCache>
                  <c:formatCode>General</c:formatCode>
                  <c:ptCount val="3"/>
                  <c:pt idx="0">
                    <c:v>0.11271390590044049</c:v>
                  </c:pt>
                  <c:pt idx="1">
                    <c:v>0.11267577934054923</c:v>
                  </c:pt>
                  <c:pt idx="2">
                    <c:v>0.135473287649877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at. amonium'!$O$17:$O$19</c:f>
              <c:strCache>
                <c:ptCount val="3"/>
                <c:pt idx="0">
                  <c:v>0 hpi</c:v>
                </c:pt>
                <c:pt idx="1">
                  <c:v>1 dpi</c:v>
                </c:pt>
                <c:pt idx="2">
                  <c:v>3 dpi</c:v>
                </c:pt>
              </c:strCache>
            </c:strRef>
          </c:cat>
          <c:val>
            <c:numRef>
              <c:f>'cat. amonium'!$I$4:$K$4</c:f>
              <c:numCache>
                <c:formatCode>General</c:formatCode>
                <c:ptCount val="3"/>
                <c:pt idx="0">
                  <c:v>0.78997499999999998</c:v>
                </c:pt>
                <c:pt idx="1">
                  <c:v>1.1281749999999999</c:v>
                </c:pt>
                <c:pt idx="2">
                  <c:v>1.3054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452-494A-9263-6A34E866DE6C}"/>
            </c:ext>
          </c:extLst>
        </c:ser>
        <c:ser>
          <c:idx val="1"/>
          <c:order val="1"/>
          <c:tx>
            <c:strRef>
              <c:f>'cat. amonium'!$H$7</c:f>
              <c:strCache>
                <c:ptCount val="1"/>
                <c:pt idx="0">
                  <c:v>mfdx1</c:v>
                </c:pt>
              </c:strCache>
            </c:strRef>
          </c:tx>
          <c:spPr>
            <a:solidFill>
              <a:srgbClr val="70AD47">
                <a:lumMod val="60000"/>
                <a:lumOff val="40000"/>
              </a:srgb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at. amonium'!$L$7:$N$7</c:f>
                <c:numCache>
                  <c:formatCode>General</c:formatCode>
                  <c:ptCount val="3"/>
                  <c:pt idx="0">
                    <c:v>4.7985206053532771E-2</c:v>
                  </c:pt>
                  <c:pt idx="1">
                    <c:v>4.6646918440557246E-2</c:v>
                  </c:pt>
                  <c:pt idx="2">
                    <c:v>0.1101354544791695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at. amonium'!$O$17:$O$19</c:f>
              <c:strCache>
                <c:ptCount val="3"/>
                <c:pt idx="0">
                  <c:v>0 hpi</c:v>
                </c:pt>
                <c:pt idx="1">
                  <c:v>1 dpi</c:v>
                </c:pt>
                <c:pt idx="2">
                  <c:v>3 dpi</c:v>
                </c:pt>
              </c:strCache>
            </c:strRef>
          </c:cat>
          <c:val>
            <c:numRef>
              <c:f>'cat. amonium'!$I$7:$K$7</c:f>
              <c:numCache>
                <c:formatCode>General</c:formatCode>
                <c:ptCount val="3"/>
                <c:pt idx="0">
                  <c:v>0.9284</c:v>
                </c:pt>
                <c:pt idx="1">
                  <c:v>0.92580000000000007</c:v>
                </c:pt>
                <c:pt idx="2">
                  <c:v>0.919366666666666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452-494A-9263-6A34E866DE6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91749160"/>
        <c:axId val="491744240"/>
      </c:barChart>
      <c:catAx>
        <c:axId val="491749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91744240"/>
        <c:crosses val="autoZero"/>
        <c:auto val="1"/>
        <c:lblAlgn val="ctr"/>
        <c:lblOffset val="100"/>
        <c:noMultiLvlLbl val="0"/>
      </c:catAx>
      <c:valAx>
        <c:axId val="4917442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917491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0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tassium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173840769903763"/>
          <c:y val="0.16898148148148148"/>
          <c:w val="0.6799282589676291"/>
          <c:h val="0.6144677748614756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cat. potassium'!$J$5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at. potassium'!$N$5:$P$5</c:f>
                <c:numCache>
                  <c:formatCode>General</c:formatCode>
                  <c:ptCount val="3"/>
                  <c:pt idx="0">
                    <c:v>1.8456278105295245</c:v>
                  </c:pt>
                  <c:pt idx="1">
                    <c:v>0.94866918101095732</c:v>
                  </c:pt>
                  <c:pt idx="2">
                    <c:v>0.574830715660417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at. potassium'!$P$15:$P$17</c:f>
              <c:strCache>
                <c:ptCount val="3"/>
                <c:pt idx="0">
                  <c:v>0 hpi</c:v>
                </c:pt>
                <c:pt idx="1">
                  <c:v>1 dpi</c:v>
                </c:pt>
                <c:pt idx="2">
                  <c:v>3 dpi</c:v>
                </c:pt>
              </c:strCache>
            </c:strRef>
          </c:cat>
          <c:val>
            <c:numRef>
              <c:f>'cat. potassium'!$K$5:$M$5</c:f>
              <c:numCache>
                <c:formatCode>General</c:formatCode>
                <c:ptCount val="3"/>
                <c:pt idx="0">
                  <c:v>15.961650000000001</c:v>
                </c:pt>
                <c:pt idx="1">
                  <c:v>20.204699999999999</c:v>
                </c:pt>
                <c:pt idx="2">
                  <c:v>18.27325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589-41E8-8AD8-ACFB297C5A7C}"/>
            </c:ext>
          </c:extLst>
        </c:ser>
        <c:ser>
          <c:idx val="1"/>
          <c:order val="1"/>
          <c:tx>
            <c:strRef>
              <c:f>'cat. potassium'!$J$8</c:f>
              <c:strCache>
                <c:ptCount val="1"/>
                <c:pt idx="0">
                  <c:v>mfdx1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at. potassium'!$N$8:$P$8</c:f>
                <c:numCache>
                  <c:formatCode>General</c:formatCode>
                  <c:ptCount val="3"/>
                  <c:pt idx="0">
                    <c:v>0.98279389073531975</c:v>
                  </c:pt>
                  <c:pt idx="1">
                    <c:v>0.42517243756700179</c:v>
                  </c:pt>
                  <c:pt idx="2">
                    <c:v>0.7326924093142136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at. potassium'!$P$15:$P$17</c:f>
              <c:strCache>
                <c:ptCount val="3"/>
                <c:pt idx="0">
                  <c:v>0 hpi</c:v>
                </c:pt>
                <c:pt idx="1">
                  <c:v>1 dpi</c:v>
                </c:pt>
                <c:pt idx="2">
                  <c:v>3 dpi</c:v>
                </c:pt>
              </c:strCache>
            </c:strRef>
          </c:cat>
          <c:val>
            <c:numRef>
              <c:f>'cat. potassium'!$K$8:$M$8</c:f>
              <c:numCache>
                <c:formatCode>General</c:formatCode>
                <c:ptCount val="3"/>
                <c:pt idx="0">
                  <c:v>17.123233333333335</c:v>
                </c:pt>
                <c:pt idx="1">
                  <c:v>16.640333333333331</c:v>
                </c:pt>
                <c:pt idx="2">
                  <c:v>14.249466666666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589-41E8-8AD8-ACFB297C5A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99363376"/>
        <c:axId val="499357472"/>
      </c:barChart>
      <c:catAx>
        <c:axId val="4993633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99357472"/>
        <c:crosses val="autoZero"/>
        <c:auto val="1"/>
        <c:lblAlgn val="ctr"/>
        <c:lblOffset val="100"/>
        <c:noMultiLvlLbl val="0"/>
      </c:catAx>
      <c:valAx>
        <c:axId val="4993574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993633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0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lcium</a:t>
            </a:r>
            <a:endParaRPr lang="en-US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0557174103237097"/>
          <c:y val="0.18097222222222226"/>
          <c:w val="0.64720603674540678"/>
          <c:h val="0.5561807378244386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cat. calcium'!$J$6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at. calcium'!$N$6:$P$6</c:f>
                <c:numCache>
                  <c:formatCode>General</c:formatCode>
                  <c:ptCount val="3"/>
                  <c:pt idx="0">
                    <c:v>0.12004999999999999</c:v>
                  </c:pt>
                  <c:pt idx="1">
                    <c:v>8.6154732410162221E-2</c:v>
                  </c:pt>
                  <c:pt idx="2">
                    <c:v>0.2836946245525283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at. calcium'!$P$20:$P$22</c:f>
              <c:strCache>
                <c:ptCount val="3"/>
                <c:pt idx="0">
                  <c:v>0 hpi</c:v>
                </c:pt>
                <c:pt idx="1">
                  <c:v>1 dpi</c:v>
                </c:pt>
                <c:pt idx="2">
                  <c:v>3 dpi</c:v>
                </c:pt>
              </c:strCache>
            </c:strRef>
          </c:cat>
          <c:val>
            <c:numRef>
              <c:f>'cat. calcium'!$K$6:$M$6</c:f>
              <c:numCache>
                <c:formatCode>General</c:formatCode>
                <c:ptCount val="3"/>
                <c:pt idx="0">
                  <c:v>1.33195</c:v>
                </c:pt>
                <c:pt idx="1">
                  <c:v>2.1247249999999998</c:v>
                </c:pt>
                <c:pt idx="2">
                  <c:v>1.35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CD8-4144-9551-1574E03EDA3E}"/>
            </c:ext>
          </c:extLst>
        </c:ser>
        <c:ser>
          <c:idx val="1"/>
          <c:order val="1"/>
          <c:tx>
            <c:strRef>
              <c:f>'cat. calcium'!$J$9</c:f>
              <c:strCache>
                <c:ptCount val="1"/>
                <c:pt idx="0">
                  <c:v>mfdx1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at. calcium'!$N$9:$P$9</c:f>
                <c:numCache>
                  <c:formatCode>General</c:formatCode>
                  <c:ptCount val="3"/>
                  <c:pt idx="0">
                    <c:v>0.35725547115008138</c:v>
                  </c:pt>
                  <c:pt idx="1">
                    <c:v>0.38376089126781343</c:v>
                  </c:pt>
                  <c:pt idx="2">
                    <c:v>0.2788098844493617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at. calcium'!$P$20:$P$22</c:f>
              <c:strCache>
                <c:ptCount val="3"/>
                <c:pt idx="0">
                  <c:v>0 hpi</c:v>
                </c:pt>
                <c:pt idx="1">
                  <c:v>1 dpi</c:v>
                </c:pt>
                <c:pt idx="2">
                  <c:v>3 dpi</c:v>
                </c:pt>
              </c:strCache>
            </c:strRef>
          </c:cat>
          <c:val>
            <c:numRef>
              <c:f>'cat. calcium'!$K$9:$M$9</c:f>
              <c:numCache>
                <c:formatCode>General</c:formatCode>
                <c:ptCount val="3"/>
                <c:pt idx="0">
                  <c:v>1.3428333333333333</c:v>
                </c:pt>
                <c:pt idx="1">
                  <c:v>1.3097666666666667</c:v>
                </c:pt>
                <c:pt idx="2">
                  <c:v>1.1475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CD8-4144-9551-1574E03EDA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7253568"/>
        <c:axId val="347250288"/>
      </c:barChart>
      <c:catAx>
        <c:axId val="347253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47250288"/>
        <c:crosses val="autoZero"/>
        <c:auto val="1"/>
        <c:lblAlgn val="ctr"/>
        <c:lblOffset val="100"/>
        <c:noMultiLvlLbl val="0"/>
      </c:catAx>
      <c:valAx>
        <c:axId val="3472502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472535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0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dium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1390507436570427"/>
          <c:y val="0.18097222222222226"/>
          <c:w val="0.64720603674540689"/>
          <c:h val="0.5978474044911052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cat. sodium'!$J$4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at. sodium'!$N$4:$P$4</c:f>
                <c:numCache>
                  <c:formatCode>General</c:formatCode>
                  <c:ptCount val="3"/>
                  <c:pt idx="0">
                    <c:v>0.17229793479126018</c:v>
                  </c:pt>
                  <c:pt idx="1">
                    <c:v>0.51682919285130624</c:v>
                  </c:pt>
                  <c:pt idx="2">
                    <c:v>0.349304257894652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at. sodium'!$Q$19:$Q$21</c:f>
              <c:strCache>
                <c:ptCount val="3"/>
                <c:pt idx="0">
                  <c:v>0 hpi</c:v>
                </c:pt>
                <c:pt idx="1">
                  <c:v>1 dpi</c:v>
                </c:pt>
                <c:pt idx="2">
                  <c:v>3 dpi</c:v>
                </c:pt>
              </c:strCache>
            </c:strRef>
          </c:cat>
          <c:val>
            <c:numRef>
              <c:f>'cat. sodium'!$K$4:$M$4</c:f>
              <c:numCache>
                <c:formatCode>General</c:formatCode>
                <c:ptCount val="3"/>
                <c:pt idx="0">
                  <c:v>3.3410499999999996</c:v>
                </c:pt>
                <c:pt idx="1">
                  <c:v>2.8498750000000004</c:v>
                </c:pt>
                <c:pt idx="2">
                  <c:v>2.9725666666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ED4-4B96-B63A-8E37E00B8E10}"/>
            </c:ext>
          </c:extLst>
        </c:ser>
        <c:ser>
          <c:idx val="1"/>
          <c:order val="1"/>
          <c:tx>
            <c:strRef>
              <c:f>'cat. sodium'!$J$7</c:f>
              <c:strCache>
                <c:ptCount val="1"/>
                <c:pt idx="0">
                  <c:v>mfdx1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at. sodium'!$N$7:$P$7</c:f>
                <c:numCache>
                  <c:formatCode>General</c:formatCode>
                  <c:ptCount val="3"/>
                  <c:pt idx="0">
                    <c:v>0.38379446485065333</c:v>
                  </c:pt>
                  <c:pt idx="1">
                    <c:v>0.38825147939190102</c:v>
                  </c:pt>
                  <c:pt idx="2">
                    <c:v>0.124462417352923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at. sodium'!$Q$19:$Q$21</c:f>
              <c:strCache>
                <c:ptCount val="3"/>
                <c:pt idx="0">
                  <c:v>0 hpi</c:v>
                </c:pt>
                <c:pt idx="1">
                  <c:v>1 dpi</c:v>
                </c:pt>
                <c:pt idx="2">
                  <c:v>3 dpi</c:v>
                </c:pt>
              </c:strCache>
            </c:strRef>
          </c:cat>
          <c:val>
            <c:numRef>
              <c:f>'cat. sodium'!$K$7:$M$7</c:f>
              <c:numCache>
                <c:formatCode>General</c:formatCode>
                <c:ptCount val="3"/>
                <c:pt idx="0">
                  <c:v>3.0079000000000007</c:v>
                </c:pt>
                <c:pt idx="1">
                  <c:v>2.8342333333333336</c:v>
                </c:pt>
                <c:pt idx="2">
                  <c:v>2.66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ED4-4B96-B63A-8E37E00B8E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41438440"/>
        <c:axId val="541438768"/>
      </c:barChart>
      <c:catAx>
        <c:axId val="541438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41438768"/>
        <c:crosses val="autoZero"/>
        <c:auto val="1"/>
        <c:lblAlgn val="ctr"/>
        <c:lblOffset val="100"/>
        <c:noMultiLvlLbl val="0"/>
      </c:catAx>
      <c:valAx>
        <c:axId val="5414387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414384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 dirty="0">
                <a:solidFill>
                  <a:schemeClr val="tx1"/>
                </a:solidFill>
              </a:rPr>
              <a:t>P. </a:t>
            </a:r>
            <a:r>
              <a:rPr lang="en-US" sz="1200" i="1" dirty="0" err="1">
                <a:solidFill>
                  <a:schemeClr val="tx1"/>
                </a:solidFill>
              </a:rPr>
              <a:t>syringae</a:t>
            </a:r>
            <a:r>
              <a:rPr lang="en-US" sz="1200" i="1" dirty="0">
                <a:solidFill>
                  <a:schemeClr val="tx1"/>
                </a:solidFill>
              </a:rPr>
              <a:t> </a:t>
            </a:r>
            <a:r>
              <a:rPr lang="en-US" sz="1200" dirty="0" err="1">
                <a:solidFill>
                  <a:schemeClr val="tx1"/>
                </a:solidFill>
              </a:rPr>
              <a:t>pv</a:t>
            </a:r>
            <a:r>
              <a:rPr lang="en-US" sz="1200" dirty="0">
                <a:solidFill>
                  <a:schemeClr val="tx1"/>
                </a:solidFill>
              </a:rPr>
              <a:t>. </a:t>
            </a:r>
            <a:r>
              <a:rPr lang="en-US" sz="1200" i="1" dirty="0">
                <a:solidFill>
                  <a:schemeClr val="tx1"/>
                </a:solidFill>
              </a:rPr>
              <a:t>tomato</a:t>
            </a:r>
            <a:r>
              <a:rPr lang="en-US" sz="1200" dirty="0">
                <a:solidFill>
                  <a:schemeClr val="tx1"/>
                </a:solidFill>
              </a:rPr>
              <a:t> T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224759405074365"/>
          <c:y val="0.15277777777777779"/>
          <c:w val="0.63219685039370088"/>
          <c:h val="0.6657487605715952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[Fe_S_screening1st.xlsx]Sheet1!$S$75</c:f>
              <c:strCache>
                <c:ptCount val="1"/>
                <c:pt idx="0">
                  <c:v>TRV2:GFP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[Fe_S_screening1st.xlsx]Sheet1!$T$76:$W$76</c:f>
                <c:numCache>
                  <c:formatCode>General</c:formatCode>
                  <c:ptCount val="4"/>
                  <c:pt idx="0">
                    <c:v>1.6754881455062431E-2</c:v>
                  </c:pt>
                  <c:pt idx="1">
                    <c:v>1.9797180876330867E-2</c:v>
                  </c:pt>
                  <c:pt idx="2">
                    <c:v>5.2062228543460556E-2</c:v>
                  </c:pt>
                  <c:pt idx="3">
                    <c:v>7.052935737075391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Fe_S_screening1st.xlsx]Sheet1!$Q$83:$Q$86</c:f>
              <c:strCache>
                <c:ptCount val="4"/>
                <c:pt idx="0">
                  <c:v>0 hpi</c:v>
                </c:pt>
                <c:pt idx="1">
                  <c:v>1 dpi</c:v>
                </c:pt>
                <c:pt idx="2">
                  <c:v>2 dpi</c:v>
                </c:pt>
                <c:pt idx="3">
                  <c:v>3 dpi</c:v>
                </c:pt>
              </c:strCache>
            </c:strRef>
          </c:cat>
          <c:val>
            <c:numRef>
              <c:f>[Fe_S_screening1st.xlsx]Sheet1!$T$75:$W$75</c:f>
              <c:numCache>
                <c:formatCode>General</c:formatCode>
                <c:ptCount val="4"/>
                <c:pt idx="0">
                  <c:v>4.510445237607918</c:v>
                </c:pt>
                <c:pt idx="1">
                  <c:v>5.8850986069788753</c:v>
                </c:pt>
                <c:pt idx="2">
                  <c:v>6.9282057642109587</c:v>
                </c:pt>
                <c:pt idx="3">
                  <c:v>7.08377423803026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EEC-464D-AD50-085D964C76C8}"/>
            </c:ext>
          </c:extLst>
        </c:ser>
        <c:ser>
          <c:idx val="1"/>
          <c:order val="1"/>
          <c:tx>
            <c:strRef>
              <c:f>[Fe_S_screening1st.xlsx]Sheet1!$S$77</c:f>
              <c:strCache>
                <c:ptCount val="1"/>
                <c:pt idx="0">
                  <c:v>TRV2:MFDX1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[Fe_S_screening1st.xlsx]Sheet1!$T$78:$W$78</c:f>
                <c:numCache>
                  <c:formatCode>General</c:formatCode>
                  <c:ptCount val="4"/>
                  <c:pt idx="0">
                    <c:v>2.8010283003998548E-2</c:v>
                  </c:pt>
                  <c:pt idx="1">
                    <c:v>2.2580505824820736E-3</c:v>
                  </c:pt>
                  <c:pt idx="2">
                    <c:v>1.2300572527670644E-2</c:v>
                  </c:pt>
                  <c:pt idx="3">
                    <c:v>1.907177991568059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Fe_S_screening1st.xlsx]Sheet1!$Q$83:$Q$86</c:f>
              <c:strCache>
                <c:ptCount val="4"/>
                <c:pt idx="0">
                  <c:v>0 hpi</c:v>
                </c:pt>
                <c:pt idx="1">
                  <c:v>1 dpi</c:v>
                </c:pt>
                <c:pt idx="2">
                  <c:v>2 dpi</c:v>
                </c:pt>
                <c:pt idx="3">
                  <c:v>3 dpi</c:v>
                </c:pt>
              </c:strCache>
            </c:strRef>
          </c:cat>
          <c:val>
            <c:numRef>
              <c:f>[Fe_S_screening1st.xlsx]Sheet1!$T$77:$W$77</c:f>
              <c:numCache>
                <c:formatCode>General</c:formatCode>
                <c:ptCount val="4"/>
                <c:pt idx="0">
                  <c:v>4.3897381190215921</c:v>
                </c:pt>
                <c:pt idx="1">
                  <c:v>6.1591099516524928</c:v>
                </c:pt>
                <c:pt idx="2">
                  <c:v>7.8728959487584902</c:v>
                </c:pt>
                <c:pt idx="3">
                  <c:v>7.42901275545243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EEC-464D-AD50-085D964C76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0486416"/>
        <c:axId val="130486808"/>
      </c:barChart>
      <c:catAx>
        <c:axId val="1304864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0486808"/>
        <c:crosses val="autoZero"/>
        <c:auto val="1"/>
        <c:lblAlgn val="ctr"/>
        <c:lblOffset val="100"/>
        <c:noMultiLvlLbl val="0"/>
      </c:catAx>
      <c:valAx>
        <c:axId val="130486808"/>
        <c:scaling>
          <c:orientation val="minMax"/>
          <c:max val="8"/>
          <c:min val="4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0486416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748125546806649"/>
          <c:y val="0.42100357247010783"/>
          <c:w val="0.22518744531933507"/>
          <c:h val="0.2043966603942488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  <c:userShapes r:id="rId5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000" b="1" i="1" dirty="0">
                <a:solidFill>
                  <a:schemeClr val="tx1"/>
                </a:solidFill>
              </a:rPr>
              <a:t>MFDX1 / ACT2</a:t>
            </a:r>
          </a:p>
        </c:rich>
      </c:tx>
      <c:layout>
        <c:manualLayout>
          <c:xMode val="edge"/>
          <c:yMode val="edge"/>
          <c:x val="0.39675485070699273"/>
          <c:y val="3.038774766014342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2622405363292017"/>
          <c:y val="0.12578326214146046"/>
          <c:w val="0.53788147784288276"/>
          <c:h val="0.6954338939673382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e-S At mutants homozygous qpcr'!$R$31:$R$32</c:f>
                <c:numCache>
                  <c:formatCode>General</c:formatCode>
                  <c:ptCount val="2"/>
                  <c:pt idx="0">
                    <c:v>1.642780034662884E-2</c:v>
                  </c:pt>
                  <c:pt idx="1">
                    <c:v>1.0002786628988084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e-S At mutants homozygous qpcr'!$P$31:$P$32</c:f>
              <c:strCache>
                <c:ptCount val="2"/>
                <c:pt idx="0">
                  <c:v>WT</c:v>
                </c:pt>
                <c:pt idx="1">
                  <c:v>mfdx1</c:v>
                </c:pt>
              </c:strCache>
            </c:strRef>
          </c:cat>
          <c:val>
            <c:numRef>
              <c:f>'fe-S At mutants homozygous qpcr'!$Q$31:$Q$32</c:f>
              <c:numCache>
                <c:formatCode>General</c:formatCode>
                <c:ptCount val="2"/>
                <c:pt idx="0">
                  <c:v>4.7917616769064322E-2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9CA-4615-9600-5A0C1300EF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50320488"/>
        <c:axId val="350324016"/>
      </c:barChart>
      <c:catAx>
        <c:axId val="3503204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0324016"/>
        <c:crosses val="autoZero"/>
        <c:auto val="1"/>
        <c:lblAlgn val="ctr"/>
        <c:lblOffset val="100"/>
        <c:noMultiLvlLbl val="0"/>
      </c:catAx>
      <c:valAx>
        <c:axId val="3503240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 dirty="0">
                    <a:solidFill>
                      <a:schemeClr val="tx1"/>
                    </a:solidFill>
                  </a:rPr>
                  <a:t>Relative expression (Log</a:t>
                </a:r>
                <a:r>
                  <a:rPr lang="en-US" b="1" baseline="-25000" dirty="0">
                    <a:solidFill>
                      <a:schemeClr val="tx1"/>
                    </a:solidFill>
                  </a:rPr>
                  <a:t>2</a:t>
                </a:r>
                <a:r>
                  <a:rPr lang="en-US" b="1" dirty="0">
                    <a:solidFill>
                      <a:schemeClr val="tx1"/>
                    </a:solidFill>
                  </a:rPr>
                  <a:t>)</a:t>
                </a:r>
              </a:p>
            </c:rich>
          </c:tx>
          <c:layout>
            <c:manualLayout>
              <c:xMode val="edge"/>
              <c:yMode val="edge"/>
              <c:x val="9.7707448861443461E-2"/>
              <c:y val="6.039313610169703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0320488"/>
        <c:crosses val="autoZero"/>
        <c:crossBetween val="between"/>
        <c:majorUnit val="2.0000000000000004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1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000" b="1" i="1">
                <a:solidFill>
                  <a:sysClr val="windowText" lastClr="000000"/>
                </a:solidFill>
              </a:rPr>
              <a:t>MFDX1</a:t>
            </a:r>
            <a:r>
              <a:rPr lang="en-US" sz="1000" b="1" i="1" baseline="0">
                <a:solidFill>
                  <a:sysClr val="windowText" lastClr="000000"/>
                </a:solidFill>
              </a:rPr>
              <a:t> / ACT2</a:t>
            </a:r>
            <a:endParaRPr lang="en-US" sz="1000" b="1" i="1">
              <a:solidFill>
                <a:sysClr val="windowText" lastClr="000000"/>
              </a:solidFill>
            </a:endParaRPr>
          </a:p>
        </c:rich>
      </c:tx>
      <c:layout>
        <c:manualLayout>
          <c:xMode val="edge"/>
          <c:yMode val="edge"/>
          <c:x val="0.3783742911153119"/>
          <c:y val="7.310704960835509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7145230192161707"/>
          <c:y val="0.17693509590674533"/>
          <c:w val="0.49500240594925626"/>
          <c:h val="0.6468135753864100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0'!$AA$14:$AA$15</c:f>
                <c:numCache>
                  <c:formatCode>General</c:formatCode>
                  <c:ptCount val="2"/>
                  <c:pt idx="0">
                    <c:v>3.6270307880960839E-3</c:v>
                  </c:pt>
                  <c:pt idx="1">
                    <c:v>1.225941144525370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0'!$X$14:$X$15</c:f>
              <c:strCache>
                <c:ptCount val="2"/>
                <c:pt idx="0">
                  <c:v>WT</c:v>
                </c:pt>
                <c:pt idx="1">
                  <c:v>mfdx1-1</c:v>
                </c:pt>
              </c:strCache>
            </c:strRef>
          </c:cat>
          <c:val>
            <c:numRef>
              <c:f>'0'!$Y$14:$Y$15</c:f>
              <c:numCache>
                <c:formatCode>General</c:formatCode>
                <c:ptCount val="2"/>
                <c:pt idx="0">
                  <c:v>6.5348226740205753E-2</c:v>
                </c:pt>
                <c:pt idx="1">
                  <c:v>2.451882289050740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B74-450C-BD42-906CA2DE4E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55601376"/>
        <c:axId val="693471568"/>
      </c:barChart>
      <c:catAx>
        <c:axId val="11556013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93471568"/>
        <c:crosses val="autoZero"/>
        <c:auto val="1"/>
        <c:lblAlgn val="ctr"/>
        <c:lblOffset val="100"/>
        <c:noMultiLvlLbl val="0"/>
      </c:catAx>
      <c:valAx>
        <c:axId val="69347156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>
                    <a:solidFill>
                      <a:sysClr val="windowText" lastClr="000000"/>
                    </a:solidFill>
                  </a:rPr>
                  <a:t>Relative expression (Log</a:t>
                </a:r>
                <a:r>
                  <a:rPr lang="en-US" b="1" baseline="-25000">
                    <a:solidFill>
                      <a:sysClr val="windowText" lastClr="000000"/>
                    </a:solidFill>
                  </a:rPr>
                  <a:t>2</a:t>
                </a:r>
                <a:r>
                  <a:rPr lang="en-US" b="1">
                    <a:solidFill>
                      <a:sysClr val="windowText" lastClr="000000"/>
                    </a:solidFill>
                  </a:rPr>
                  <a:t>)</a:t>
                </a:r>
              </a:p>
            </c:rich>
          </c:tx>
          <c:layout>
            <c:manualLayout>
              <c:xMode val="edge"/>
              <c:yMode val="edge"/>
              <c:x val="7.8386794278314451E-2"/>
              <c:y val="0.1789971423284882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556013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  <c:userShapes r:id="rId4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0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gnesium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071272965879265"/>
          <c:y val="0.1875"/>
          <c:w val="0.5789838145231847"/>
          <c:h val="0.5959492563429571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cat. magnesium'!$H$5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rgbClr val="5B9BD5">
                <a:lumMod val="60000"/>
                <a:lumOff val="40000"/>
              </a:srgb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at. magnesium'!$L$5:$N$5</c:f>
                <c:numCache>
                  <c:formatCode>General</c:formatCode>
                  <c:ptCount val="3"/>
                  <c:pt idx="0">
                    <c:v>6.3795777681598984E-2</c:v>
                  </c:pt>
                  <c:pt idx="1">
                    <c:v>3.1764045449742893E-2</c:v>
                  </c:pt>
                  <c:pt idx="2">
                    <c:v>5.979928580955914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at. magnesium'!$O$15:$O$17</c:f>
              <c:strCache>
                <c:ptCount val="3"/>
                <c:pt idx="0">
                  <c:v>0 hpi</c:v>
                </c:pt>
                <c:pt idx="1">
                  <c:v>1 dpi</c:v>
                </c:pt>
                <c:pt idx="2">
                  <c:v>3 dpi</c:v>
                </c:pt>
              </c:strCache>
            </c:strRef>
          </c:cat>
          <c:val>
            <c:numRef>
              <c:f>'cat. magnesium'!$I$5:$K$5</c:f>
              <c:numCache>
                <c:formatCode>General</c:formatCode>
                <c:ptCount val="3"/>
                <c:pt idx="0">
                  <c:v>0.216225</c:v>
                </c:pt>
                <c:pt idx="1">
                  <c:v>0.33842499999999998</c:v>
                </c:pt>
                <c:pt idx="2">
                  <c:v>0.231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319-4CDB-ACEE-37B36BF48B58}"/>
            </c:ext>
          </c:extLst>
        </c:ser>
        <c:ser>
          <c:idx val="1"/>
          <c:order val="1"/>
          <c:tx>
            <c:strRef>
              <c:f>'cat. magnesium'!$H$8</c:f>
              <c:strCache>
                <c:ptCount val="1"/>
                <c:pt idx="0">
                  <c:v>mfdx1</c:v>
                </c:pt>
              </c:strCache>
            </c:strRef>
          </c:tx>
          <c:spPr>
            <a:solidFill>
              <a:srgbClr val="70AD47">
                <a:lumMod val="60000"/>
                <a:lumOff val="40000"/>
              </a:srgb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at. magnesium'!$L$8:$N$8</c:f>
                <c:numCache>
                  <c:formatCode>General</c:formatCode>
                  <c:ptCount val="3"/>
                  <c:pt idx="0">
                    <c:v>6.1163401366067495E-2</c:v>
                  </c:pt>
                  <c:pt idx="1">
                    <c:v>5.0082748194030517E-2</c:v>
                  </c:pt>
                  <c:pt idx="2">
                    <c:v>3.131248419826602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at. magnesium'!$O$15:$O$17</c:f>
              <c:strCache>
                <c:ptCount val="3"/>
                <c:pt idx="0">
                  <c:v>0 hpi</c:v>
                </c:pt>
                <c:pt idx="1">
                  <c:v>1 dpi</c:v>
                </c:pt>
                <c:pt idx="2">
                  <c:v>3 dpi</c:v>
                </c:pt>
              </c:strCache>
            </c:strRef>
          </c:cat>
          <c:val>
            <c:numRef>
              <c:f>'cat. magnesium'!$I$8:$K$8</c:f>
              <c:numCache>
                <c:formatCode>General</c:formatCode>
                <c:ptCount val="3"/>
                <c:pt idx="0">
                  <c:v>0.21566666666666667</c:v>
                </c:pt>
                <c:pt idx="1">
                  <c:v>0.19333333333333333</c:v>
                </c:pt>
                <c:pt idx="2">
                  <c:v>0.19336666666666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319-4CDB-ACEE-37B36BF48B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99356488"/>
        <c:axId val="499358128"/>
      </c:barChart>
      <c:catAx>
        <c:axId val="4993564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99358128"/>
        <c:crosses val="autoZero"/>
        <c:auto val="1"/>
        <c:lblAlgn val="ctr"/>
        <c:lblOffset val="100"/>
        <c:noMultiLvlLbl val="0"/>
      </c:catAx>
      <c:valAx>
        <c:axId val="4993581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993564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0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itrat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250161854768154"/>
          <c:y val="0.21800925925925929"/>
          <c:w val="0.56387270341207363"/>
          <c:h val="0.579328885972586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citrate!$J$5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citrate!$N$5:$P$5</c:f>
                <c:numCache>
                  <c:formatCode>General</c:formatCode>
                  <c:ptCount val="3"/>
                  <c:pt idx="0">
                    <c:v>6.634128930512781E-3</c:v>
                  </c:pt>
                  <c:pt idx="1">
                    <c:v>6.1314761681017758E-3</c:v>
                  </c:pt>
                  <c:pt idx="2">
                    <c:v>1.04661955838787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itrate!$R$21:$R$23</c:f>
              <c:strCache>
                <c:ptCount val="3"/>
                <c:pt idx="0">
                  <c:v>0 hpi</c:v>
                </c:pt>
                <c:pt idx="1">
                  <c:v>1 dpi</c:v>
                </c:pt>
                <c:pt idx="2">
                  <c:v>3 dpi</c:v>
                </c:pt>
              </c:strCache>
            </c:strRef>
          </c:cat>
          <c:val>
            <c:numRef>
              <c:f>citrate!$K$5:$M$5</c:f>
              <c:numCache>
                <c:formatCode>General</c:formatCode>
                <c:ptCount val="3"/>
                <c:pt idx="0">
                  <c:v>0.12273333333333332</c:v>
                </c:pt>
                <c:pt idx="1">
                  <c:v>8.1000000000000003E-2</c:v>
                </c:pt>
                <c:pt idx="2">
                  <c:v>0.4940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575-4C90-818C-146B9EDF5029}"/>
            </c:ext>
          </c:extLst>
        </c:ser>
        <c:ser>
          <c:idx val="1"/>
          <c:order val="1"/>
          <c:tx>
            <c:strRef>
              <c:f>citrate!$J$8</c:f>
              <c:strCache>
                <c:ptCount val="1"/>
                <c:pt idx="0">
                  <c:v>mfdx1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citrate!$N$8:$P$8</c:f>
                <c:numCache>
                  <c:formatCode>General</c:formatCode>
                  <c:ptCount val="3"/>
                  <c:pt idx="0">
                    <c:v>2.3640528406390127E-2</c:v>
                  </c:pt>
                  <c:pt idx="1">
                    <c:v>3.3413987839426368E-2</c:v>
                  </c:pt>
                  <c:pt idx="2">
                    <c:v>9.941947118145412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itrate!$R$21:$R$23</c:f>
              <c:strCache>
                <c:ptCount val="3"/>
                <c:pt idx="0">
                  <c:v>0 hpi</c:v>
                </c:pt>
                <c:pt idx="1">
                  <c:v>1 dpi</c:v>
                </c:pt>
                <c:pt idx="2">
                  <c:v>3 dpi</c:v>
                </c:pt>
              </c:strCache>
            </c:strRef>
          </c:cat>
          <c:val>
            <c:numRef>
              <c:f>citrate!$K$8:$M$8</c:f>
              <c:numCache>
                <c:formatCode>General</c:formatCode>
                <c:ptCount val="3"/>
                <c:pt idx="0">
                  <c:v>0.17989999999999998</c:v>
                </c:pt>
                <c:pt idx="1">
                  <c:v>0.12033333333333333</c:v>
                </c:pt>
                <c:pt idx="2">
                  <c:v>0.393366666666666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575-4C90-818C-146B9EDF50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41451560"/>
        <c:axId val="541443360"/>
      </c:barChart>
      <c:catAx>
        <c:axId val="5414515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41443360"/>
        <c:crosses val="autoZero"/>
        <c:auto val="1"/>
        <c:lblAlgn val="ctr"/>
        <c:lblOffset val="100"/>
        <c:noMultiLvlLbl val="0"/>
      </c:catAx>
      <c:valAx>
        <c:axId val="5414433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414515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0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lat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6112729658792649"/>
          <c:y val="0.21337962962962964"/>
          <c:w val="0.52498381452318466"/>
          <c:h val="0.570069626713327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malate!$J$5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rgbClr val="5B9BD5">
                <a:lumMod val="60000"/>
                <a:lumOff val="40000"/>
              </a:srgb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malate!$L$5,malate!$N$5)</c:f>
                <c:numCache>
                  <c:formatCode>General</c:formatCode>
                  <c:ptCount val="2"/>
                  <c:pt idx="0">
                    <c:v>0.13306932403826163</c:v>
                  </c:pt>
                  <c:pt idx="1">
                    <c:v>7.843854016574541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alate!$O$16:$O$17</c:f>
              <c:strCache>
                <c:ptCount val="2"/>
                <c:pt idx="0">
                  <c:v>0 hpi</c:v>
                </c:pt>
                <c:pt idx="1">
                  <c:v>1 dpi</c:v>
                </c:pt>
              </c:strCache>
            </c:strRef>
          </c:cat>
          <c:val>
            <c:numRef>
              <c:f>(malate!$K$5,malate!$M$5)</c:f>
              <c:numCache>
                <c:formatCode>General</c:formatCode>
                <c:ptCount val="2"/>
                <c:pt idx="0">
                  <c:v>1.0602</c:v>
                </c:pt>
                <c:pt idx="1">
                  <c:v>0.88107500000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205-4244-85C2-8173BA598C7C}"/>
            </c:ext>
          </c:extLst>
        </c:ser>
        <c:ser>
          <c:idx val="1"/>
          <c:order val="1"/>
          <c:tx>
            <c:strRef>
              <c:f>malate!$J$8</c:f>
              <c:strCache>
                <c:ptCount val="1"/>
                <c:pt idx="0">
                  <c:v>mfdx1-1</c:v>
                </c:pt>
              </c:strCache>
            </c:strRef>
          </c:tx>
          <c:spPr>
            <a:solidFill>
              <a:srgbClr val="70AD47">
                <a:lumMod val="60000"/>
                <a:lumOff val="40000"/>
              </a:srgb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malate!$L$8,malate!$N$8)</c:f>
                <c:numCache>
                  <c:formatCode>General</c:formatCode>
                  <c:ptCount val="2"/>
                  <c:pt idx="0">
                    <c:v>6.9874399222223479E-2</c:v>
                  </c:pt>
                  <c:pt idx="1">
                    <c:v>0.1197752965626335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alate!$O$16:$O$17</c:f>
              <c:strCache>
                <c:ptCount val="2"/>
                <c:pt idx="0">
                  <c:v>0 hpi</c:v>
                </c:pt>
                <c:pt idx="1">
                  <c:v>1 dpi</c:v>
                </c:pt>
              </c:strCache>
            </c:strRef>
          </c:cat>
          <c:val>
            <c:numRef>
              <c:f>(malate!$K$8,malate!$M$8)</c:f>
              <c:numCache>
                <c:formatCode>General</c:formatCode>
                <c:ptCount val="2"/>
                <c:pt idx="0">
                  <c:v>0.8420333333333333</c:v>
                </c:pt>
                <c:pt idx="1">
                  <c:v>0.949733333333332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205-4244-85C2-8173BA598C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8176896"/>
        <c:axId val="348174272"/>
      </c:barChart>
      <c:catAx>
        <c:axId val="3481768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48174272"/>
        <c:crosses val="autoZero"/>
        <c:auto val="1"/>
        <c:lblAlgn val="ctr"/>
        <c:lblOffset val="100"/>
        <c:noMultiLvlLbl val="0"/>
      </c:catAx>
      <c:valAx>
        <c:axId val="3481742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481768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000" b="1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</c:legendEntry>
      <c:layout>
        <c:manualLayout>
          <c:xMode val="edge"/>
          <c:yMode val="edge"/>
          <c:x val="0.34185292858433663"/>
          <c:y val="0.89942822932088318"/>
          <c:w val="0.30089107361818096"/>
          <c:h val="0.1005717706791169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0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itrate</a:t>
            </a:r>
          </a:p>
        </c:rich>
      </c:tx>
      <c:layout>
        <c:manualLayout>
          <c:xMode val="edge"/>
          <c:yMode val="edge"/>
          <c:x val="0.40393744531933506"/>
          <c:y val="6.944444444444444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437918951230573"/>
          <c:y val="0.19415138801080525"/>
          <c:w val="0.60735705157274189"/>
          <c:h val="0.5674935341111557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nitrate!$I$5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rgbClr val="5B9BD5">
                <a:lumMod val="60000"/>
                <a:lumOff val="40000"/>
              </a:srgb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nitrate!$M$5:$O$5</c:f>
                <c:numCache>
                  <c:formatCode>General</c:formatCode>
                  <c:ptCount val="3"/>
                  <c:pt idx="0">
                    <c:v>1.5114130048567074</c:v>
                  </c:pt>
                  <c:pt idx="1">
                    <c:v>2.3776536869359202</c:v>
                  </c:pt>
                  <c:pt idx="2">
                    <c:v>1.48010819030230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nitrate!$P$18:$P$20</c:f>
              <c:strCache>
                <c:ptCount val="3"/>
                <c:pt idx="0">
                  <c:v>0 hpi</c:v>
                </c:pt>
                <c:pt idx="1">
                  <c:v>1 dpi</c:v>
                </c:pt>
                <c:pt idx="2">
                  <c:v>3 dpi</c:v>
                </c:pt>
              </c:strCache>
            </c:strRef>
          </c:cat>
          <c:val>
            <c:numRef>
              <c:f>nitrate!$J$5:$L$5</c:f>
              <c:numCache>
                <c:formatCode>General</c:formatCode>
                <c:ptCount val="3"/>
                <c:pt idx="0">
                  <c:v>15.485975</c:v>
                </c:pt>
                <c:pt idx="1">
                  <c:v>18.75055</c:v>
                </c:pt>
                <c:pt idx="2">
                  <c:v>15.40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D19-4D2B-953E-CC846D78E97D}"/>
            </c:ext>
          </c:extLst>
        </c:ser>
        <c:ser>
          <c:idx val="1"/>
          <c:order val="1"/>
          <c:tx>
            <c:strRef>
              <c:f>nitrate!$I$8</c:f>
              <c:strCache>
                <c:ptCount val="1"/>
                <c:pt idx="0">
                  <c:v>mfdx1</c:v>
                </c:pt>
              </c:strCache>
            </c:strRef>
          </c:tx>
          <c:spPr>
            <a:solidFill>
              <a:srgbClr val="70AD47">
                <a:lumMod val="60000"/>
                <a:lumOff val="40000"/>
              </a:srgb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nitrate!$M$8:$O$8</c:f>
                <c:numCache>
                  <c:formatCode>General</c:formatCode>
                  <c:ptCount val="3"/>
                  <c:pt idx="0">
                    <c:v>1.7693427103494197</c:v>
                  </c:pt>
                  <c:pt idx="1">
                    <c:v>0.58608653940068178</c:v>
                  </c:pt>
                  <c:pt idx="2">
                    <c:v>0.7549096535347786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nitrate!$P$18:$P$20</c:f>
              <c:strCache>
                <c:ptCount val="3"/>
                <c:pt idx="0">
                  <c:v>0 hpi</c:v>
                </c:pt>
                <c:pt idx="1">
                  <c:v>1 dpi</c:v>
                </c:pt>
                <c:pt idx="2">
                  <c:v>3 dpi</c:v>
                </c:pt>
              </c:strCache>
            </c:strRef>
          </c:cat>
          <c:val>
            <c:numRef>
              <c:f>nitrate!$J$8:$L$8</c:f>
              <c:numCache>
                <c:formatCode>General</c:formatCode>
                <c:ptCount val="3"/>
                <c:pt idx="0">
                  <c:v>16.897966666666665</c:v>
                </c:pt>
                <c:pt idx="1">
                  <c:v>15.723233333333333</c:v>
                </c:pt>
                <c:pt idx="2">
                  <c:v>12.84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D19-4D2B-953E-CC846D78E9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40144968"/>
        <c:axId val="540145296"/>
      </c:barChart>
      <c:catAx>
        <c:axId val="540144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40145296"/>
        <c:crosses val="autoZero"/>
        <c:auto val="1"/>
        <c:lblAlgn val="ctr"/>
        <c:lblOffset val="100"/>
        <c:noMultiLvlLbl val="0"/>
      </c:catAx>
      <c:valAx>
        <c:axId val="5401452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401449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0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lfat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421506522211039"/>
          <c:y val="0.20224720001602853"/>
          <c:w val="0.71275240594925648"/>
          <c:h val="0.5964658063575387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ulfate!$I$6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ulfate!$M$6:$O$6</c:f>
                <c:numCache>
                  <c:formatCode>General</c:formatCode>
                  <c:ptCount val="3"/>
                  <c:pt idx="0">
                    <c:v>0.74312757625009351</c:v>
                  </c:pt>
                  <c:pt idx="1">
                    <c:v>0.80331839344683686</c:v>
                  </c:pt>
                  <c:pt idx="2">
                    <c:v>0.681207642108238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lfate!$L$18:$L$20</c:f>
              <c:strCache>
                <c:ptCount val="3"/>
                <c:pt idx="0">
                  <c:v>0 hpi</c:v>
                </c:pt>
                <c:pt idx="1">
                  <c:v>1 dpi</c:v>
                </c:pt>
                <c:pt idx="2">
                  <c:v>3 dpi</c:v>
                </c:pt>
              </c:strCache>
            </c:strRef>
          </c:cat>
          <c:val>
            <c:numRef>
              <c:f>sulfate!$J$6:$L$6</c:f>
              <c:numCache>
                <c:formatCode>General</c:formatCode>
                <c:ptCount val="3"/>
                <c:pt idx="0">
                  <c:v>6.3440749999999992</c:v>
                </c:pt>
                <c:pt idx="1">
                  <c:v>6.9075749999999996</c:v>
                </c:pt>
                <c:pt idx="2">
                  <c:v>5.3020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D96-4D16-8398-7B5E4A9C16DA}"/>
            </c:ext>
          </c:extLst>
        </c:ser>
        <c:ser>
          <c:idx val="1"/>
          <c:order val="1"/>
          <c:tx>
            <c:strRef>
              <c:f>sulfate!$I$9</c:f>
              <c:strCache>
                <c:ptCount val="1"/>
                <c:pt idx="0">
                  <c:v>mfdx1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ulfate!$M$9:$O$9</c:f>
                <c:numCache>
                  <c:formatCode>General</c:formatCode>
                  <c:ptCount val="3"/>
                  <c:pt idx="0">
                    <c:v>0.33418659707813952</c:v>
                  </c:pt>
                  <c:pt idx="1">
                    <c:v>0.19918836562409972</c:v>
                  </c:pt>
                  <c:pt idx="2">
                    <c:v>0.1905880242827442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lfate!$L$18:$L$20</c:f>
              <c:strCache>
                <c:ptCount val="3"/>
                <c:pt idx="0">
                  <c:v>0 hpi</c:v>
                </c:pt>
                <c:pt idx="1">
                  <c:v>1 dpi</c:v>
                </c:pt>
                <c:pt idx="2">
                  <c:v>3 dpi</c:v>
                </c:pt>
              </c:strCache>
            </c:strRef>
          </c:cat>
          <c:val>
            <c:numRef>
              <c:f>sulfate!$J$9:$L$9</c:f>
              <c:numCache>
                <c:formatCode>General</c:formatCode>
                <c:ptCount val="3"/>
                <c:pt idx="0">
                  <c:v>6.4287333333333336</c:v>
                </c:pt>
                <c:pt idx="1">
                  <c:v>5.8551000000000002</c:v>
                </c:pt>
                <c:pt idx="2">
                  <c:v>4.74299999999999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D96-4D16-8398-7B5E4A9C16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7254224"/>
        <c:axId val="347252256"/>
      </c:barChart>
      <c:catAx>
        <c:axId val="3472542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47252256"/>
        <c:crosses val="autoZero"/>
        <c:auto val="1"/>
        <c:lblAlgn val="ctr"/>
        <c:lblOffset val="100"/>
        <c:noMultiLvlLbl val="0"/>
      </c:catAx>
      <c:valAx>
        <c:axId val="3472522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472542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435</cdr:x>
      <cdr:y>0.54998</cdr:y>
    </cdr:from>
    <cdr:to>
      <cdr:x>0.78378</cdr:x>
      <cdr:y>0.64027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2100745" y="1209427"/>
          <a:ext cx="457970" cy="1985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dirty="0">
              <a:latin typeface="Arial" panose="020B0604020202020204" pitchFamily="34" charset="0"/>
              <a:cs typeface="Arial" panose="020B0604020202020204" pitchFamily="34" charset="0"/>
            </a:rPr>
            <a:t>***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4844</cdr:x>
      <cdr:y>0.1811</cdr:y>
    </cdr:from>
    <cdr:to>
      <cdr:x>0.11789</cdr:x>
      <cdr:y>0.82182</cdr:y>
    </cdr:to>
    <cdr:sp macro="" textlink="">
      <cdr:nvSpPr>
        <cdr:cNvPr id="2" name="TextBox 1"/>
        <cdr:cNvSpPr txBox="1"/>
      </cdr:nvSpPr>
      <cdr:spPr>
        <a:xfrm xmlns:a="http://schemas.openxmlformats.org/drawingml/2006/main" rot="16200000">
          <a:off x="-424368" y="1134495"/>
          <a:ext cx="1668126" cy="342111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b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rPr>
            <a:t>Log</a:t>
          </a:r>
          <a:r>
            <a:rPr lang="en-US" sz="1000" b="1" baseline="-250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rPr>
            <a:t>10</a:t>
          </a:r>
          <a:r>
            <a:rPr lang="en-US" sz="1000" b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rPr>
            <a:t> CFU/leaf disc (cm</a:t>
          </a:r>
          <a:r>
            <a:rPr lang="en-US" sz="1000" b="1" baseline="300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rPr>
            <a:t>2</a:t>
          </a:r>
          <a:r>
            <a:rPr lang="en-US" sz="1000" b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rPr>
            <a:t>)</a:t>
          </a:r>
          <a:endParaRPr lang="en-US" sz="1000" b="1" baseline="30000">
            <a:solidFill>
              <a:sysClr val="windowText" lastClr="000000"/>
            </a:solidFill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6909</cdr:x>
      <cdr:y>0.16712</cdr:y>
    </cdr:from>
    <cdr:to>
      <cdr:x>0.84206</cdr:x>
      <cdr:y>0.27983</cdr:y>
    </cdr:to>
    <cdr:sp macro="" textlink="">
      <cdr:nvSpPr>
        <cdr:cNvPr id="4" name="TextBox 6"/>
        <cdr:cNvSpPr txBox="1"/>
      </cdr:nvSpPr>
      <cdr:spPr>
        <a:xfrm xmlns:a="http://schemas.openxmlformats.org/drawingml/2006/main">
          <a:off x="3196069" y="457387"/>
          <a:ext cx="699263" cy="308471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dirty="0">
              <a:latin typeface="Arial" panose="020B0604020202020204" pitchFamily="34" charset="0"/>
              <a:cs typeface="Arial" panose="020B0604020202020204" pitchFamily="34" charset="0"/>
            </a:rPr>
            <a:t>****</a:t>
          </a:r>
        </a:p>
      </cdr:txBody>
    </cdr:sp>
  </cdr:relSizeAnchor>
  <cdr:relSizeAnchor xmlns:cdr="http://schemas.openxmlformats.org/drawingml/2006/chartDrawing">
    <cdr:from>
      <cdr:x>0.52507</cdr:x>
      <cdr:y>0.10178</cdr:y>
    </cdr:from>
    <cdr:to>
      <cdr:x>0.65708</cdr:x>
      <cdr:y>0.21449</cdr:y>
    </cdr:to>
    <cdr:sp macro="" textlink="">
      <cdr:nvSpPr>
        <cdr:cNvPr id="5" name="TextBox 6"/>
        <cdr:cNvSpPr txBox="1"/>
      </cdr:nvSpPr>
      <cdr:spPr>
        <a:xfrm xmlns:a="http://schemas.openxmlformats.org/drawingml/2006/main">
          <a:off x="2428976" y="278567"/>
          <a:ext cx="610675" cy="308471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dirty="0">
              <a:latin typeface="Arial" panose="020B0604020202020204" pitchFamily="34" charset="0"/>
              <a:cs typeface="Arial" panose="020B0604020202020204" pitchFamily="34" charset="0"/>
            </a:rPr>
            <a:t>****</a:t>
          </a:r>
        </a:p>
      </cdr:txBody>
    </cdr:sp>
  </cdr:relSizeAnchor>
  <cdr:relSizeAnchor xmlns:cdr="http://schemas.openxmlformats.org/drawingml/2006/chartDrawing">
    <cdr:from>
      <cdr:x>0.38087</cdr:x>
      <cdr:y>0.35479</cdr:y>
    </cdr:from>
    <cdr:to>
      <cdr:x>0.47184</cdr:x>
      <cdr:y>0.4675</cdr:y>
    </cdr:to>
    <cdr:sp macro="" textlink="">
      <cdr:nvSpPr>
        <cdr:cNvPr id="6" name="TextBox 6"/>
        <cdr:cNvSpPr txBox="1"/>
      </cdr:nvSpPr>
      <cdr:spPr>
        <a:xfrm xmlns:a="http://schemas.openxmlformats.org/drawingml/2006/main">
          <a:off x="1761872" y="970996"/>
          <a:ext cx="420825" cy="30847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dirty="0">
              <a:latin typeface="Arial" panose="020B0604020202020204" pitchFamily="34" charset="0"/>
              <a:cs typeface="Arial" panose="020B0604020202020204" pitchFamily="34" charset="0"/>
            </a:rPr>
            <a:t>**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68839</cdr:x>
      <cdr:y>0.68364</cdr:y>
    </cdr:from>
    <cdr:to>
      <cdr:x>0.74939</cdr:x>
      <cdr:y>0.77482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961989" y="1428576"/>
          <a:ext cx="173856" cy="19053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dirty="0"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en-US" sz="12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57656</cdr:x>
      <cdr:y>0.41514</cdr:y>
    </cdr:from>
    <cdr:to>
      <cdr:x>0.71456</cdr:x>
      <cdr:y>0.50653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166ECDCB-D7E0-41DF-B67A-AD6C41993B30}"/>
            </a:ext>
          </a:extLst>
        </cdr:cNvPr>
        <cdr:cNvSpPr txBox="1"/>
      </cdr:nvSpPr>
      <cdr:spPr>
        <a:xfrm xmlns:a="http://schemas.openxmlformats.org/drawingml/2006/main">
          <a:off x="1936750" y="1009650"/>
          <a:ext cx="463550" cy="2222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400">
              <a:latin typeface="Arial" panose="020B0604020202020204" pitchFamily="34" charset="0"/>
              <a:cs typeface="Arial" panose="020B0604020202020204" pitchFamily="34" charset="0"/>
            </a:rPr>
            <a:t>****</a:t>
          </a:r>
          <a:endParaRPr lang="en-US" sz="110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48501</cdr:x>
      <cdr:y>0.31137</cdr:y>
    </cdr:from>
    <cdr:to>
      <cdr:x>0.56802</cdr:x>
      <cdr:y>0.38953</cdr:y>
    </cdr:to>
    <cdr:sp macro="" textlink="">
      <cdr:nvSpPr>
        <cdr:cNvPr id="2" name="TextBox 7"/>
        <cdr:cNvSpPr txBox="1"/>
      </cdr:nvSpPr>
      <cdr:spPr>
        <a:xfrm xmlns:a="http://schemas.openxmlformats.org/drawingml/2006/main">
          <a:off x="1746250" y="765175"/>
          <a:ext cx="298863" cy="19208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>
              <a:latin typeface="Arial" panose="020B0604020202020204" pitchFamily="34" charset="0"/>
              <a:cs typeface="Arial" panose="020B0604020202020204" pitchFamily="34" charset="0"/>
            </a:rPr>
            <a:t>*</a:t>
          </a:r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3127</cdr:x>
      <cdr:y>0.51838</cdr:y>
    </cdr:from>
    <cdr:to>
      <cdr:x>0.3873</cdr:x>
      <cdr:y>0.59091</cdr:y>
    </cdr:to>
    <cdr:sp macro="" textlink="">
      <cdr:nvSpPr>
        <cdr:cNvPr id="2" name="TextBox 7"/>
        <cdr:cNvSpPr txBox="1"/>
      </cdr:nvSpPr>
      <cdr:spPr>
        <a:xfrm xmlns:a="http://schemas.openxmlformats.org/drawingml/2006/main">
          <a:off x="1250950" y="1298575"/>
          <a:ext cx="298447" cy="181704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dirty="0">
              <a:latin typeface="Arial" panose="020B0604020202020204" pitchFamily="34" charset="0"/>
              <a:cs typeface="Arial" panose="020B0604020202020204" pitchFamily="34" charset="0"/>
            </a:rPr>
            <a:t>*</a:t>
          </a:r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73303</cdr:x>
      <cdr:y>0.36836</cdr:y>
    </cdr:from>
    <cdr:to>
      <cdr:x>0.87935</cdr:x>
      <cdr:y>0.48007</cdr:y>
    </cdr:to>
    <cdr:sp macro="" textlink="">
      <cdr:nvSpPr>
        <cdr:cNvPr id="2" name="TextBox 7"/>
        <cdr:cNvSpPr txBox="1"/>
      </cdr:nvSpPr>
      <cdr:spPr>
        <a:xfrm xmlns:a="http://schemas.openxmlformats.org/drawingml/2006/main">
          <a:off x="2169297" y="716445"/>
          <a:ext cx="433015" cy="21726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dirty="0">
              <a:latin typeface="Arial" panose="020B0604020202020204" pitchFamily="34" charset="0"/>
              <a:cs typeface="Arial" panose="020B0604020202020204" pitchFamily="34" charset="0"/>
            </a:rPr>
            <a:t>**</a:t>
          </a:r>
          <a:endParaRPr lang="en-US" sz="11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.72095</cdr:x>
      <cdr:y>0.33463</cdr:y>
    </cdr:from>
    <cdr:to>
      <cdr:x>0.80079</cdr:x>
      <cdr:y>0.41279</cdr:y>
    </cdr:to>
    <cdr:sp macro="" textlink="">
      <cdr:nvSpPr>
        <cdr:cNvPr id="2" name="TextBox 7"/>
        <cdr:cNvSpPr txBox="1"/>
      </cdr:nvSpPr>
      <cdr:spPr>
        <a:xfrm xmlns:a="http://schemas.openxmlformats.org/drawingml/2006/main">
          <a:off x="2698750" y="822325"/>
          <a:ext cx="298863" cy="19208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>
              <a:latin typeface="Arial" panose="020B0604020202020204" pitchFamily="34" charset="0"/>
              <a:cs typeface="Arial" panose="020B0604020202020204" pitchFamily="34" charset="0"/>
            </a:rPr>
            <a:t>*</a:t>
          </a:r>
        </a:p>
      </cdr:txBody>
    </cdr:sp>
  </cdr:relSizeAnchor>
  <cdr:relSizeAnchor xmlns:cdr="http://schemas.openxmlformats.org/drawingml/2006/chartDrawing">
    <cdr:from>
      <cdr:x>0.49449</cdr:x>
      <cdr:y>0.27261</cdr:y>
    </cdr:from>
    <cdr:to>
      <cdr:x>0.57433</cdr:x>
      <cdr:y>0.35077</cdr:y>
    </cdr:to>
    <cdr:sp macro="" textlink="">
      <cdr:nvSpPr>
        <cdr:cNvPr id="3" name="TextBox 7"/>
        <cdr:cNvSpPr txBox="1"/>
      </cdr:nvSpPr>
      <cdr:spPr>
        <a:xfrm xmlns:a="http://schemas.openxmlformats.org/drawingml/2006/main">
          <a:off x="1851025" y="669925"/>
          <a:ext cx="298863" cy="19208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>
              <a:latin typeface="Arial" panose="020B0604020202020204" pitchFamily="34" charset="0"/>
              <a:cs typeface="Arial" panose="020B0604020202020204" pitchFamily="34" charset="0"/>
            </a:rPr>
            <a:t>*</a:t>
          </a:r>
        </a:p>
      </cdr:txBody>
    </cdr:sp>
  </cdr:relSizeAnchor>
</c:userShapes>
</file>

<file path=ppt/drawings/drawing9.xml><?xml version="1.0" encoding="utf-8"?>
<c:userShapes xmlns:c="http://schemas.openxmlformats.org/drawingml/2006/chart">
  <cdr:relSizeAnchor xmlns:cdr="http://schemas.openxmlformats.org/drawingml/2006/chartDrawing">
    <cdr:from>
      <cdr:x>0.52248</cdr:x>
      <cdr:y>0.27156</cdr:y>
    </cdr:from>
    <cdr:to>
      <cdr:x>0.60751</cdr:x>
      <cdr:y>0.33616</cdr:y>
    </cdr:to>
    <cdr:sp macro="" textlink="">
      <cdr:nvSpPr>
        <cdr:cNvPr id="2" name="TextBox 7"/>
        <cdr:cNvSpPr txBox="1"/>
      </cdr:nvSpPr>
      <cdr:spPr>
        <a:xfrm xmlns:a="http://schemas.openxmlformats.org/drawingml/2006/main">
          <a:off x="1955800" y="669925"/>
          <a:ext cx="318300" cy="15937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>
              <a:latin typeface="Arial" panose="020B0604020202020204" pitchFamily="34" charset="0"/>
              <a:cs typeface="Arial" panose="020B0604020202020204" pitchFamily="34" charset="0"/>
            </a:rPr>
            <a:t>*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6AF29-E7E5-4CDC-8BFA-21AF80ACB645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04EF8-3AC3-4DBD-AA4D-1382D9957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7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6AF29-E7E5-4CDC-8BFA-21AF80ACB645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04EF8-3AC3-4DBD-AA4D-1382D9957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23902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6AF29-E7E5-4CDC-8BFA-21AF80ACB645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04EF8-3AC3-4DBD-AA4D-1382D9957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8815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6AF29-E7E5-4CDC-8BFA-21AF80ACB645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04EF8-3AC3-4DBD-AA4D-1382D9957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84417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6AF29-E7E5-4CDC-8BFA-21AF80ACB645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04EF8-3AC3-4DBD-AA4D-1382D9957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5639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6AF29-E7E5-4CDC-8BFA-21AF80ACB645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04EF8-3AC3-4DBD-AA4D-1382D9957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2126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6AF29-E7E5-4CDC-8BFA-21AF80ACB645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04EF8-3AC3-4DBD-AA4D-1382D9957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9960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6AF29-E7E5-4CDC-8BFA-21AF80ACB645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04EF8-3AC3-4DBD-AA4D-1382D9957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525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6AF29-E7E5-4CDC-8BFA-21AF80ACB645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04EF8-3AC3-4DBD-AA4D-1382D9957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65759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6AF29-E7E5-4CDC-8BFA-21AF80ACB645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04EF8-3AC3-4DBD-AA4D-1382D9957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532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6AF29-E7E5-4CDC-8BFA-21AF80ACB645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04EF8-3AC3-4DBD-AA4D-1382D9957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7334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56AF29-E7E5-4CDC-8BFA-21AF80ACB645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A04EF8-3AC3-4DBD-AA4D-1382D9957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14099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1.xml"/><Relationship Id="rId3" Type="http://schemas.openxmlformats.org/officeDocument/2006/relationships/chart" Target="../charts/chart6.xml"/><Relationship Id="rId7" Type="http://schemas.openxmlformats.org/officeDocument/2006/relationships/chart" Target="../charts/chart10.xml"/><Relationship Id="rId12" Type="http://schemas.openxmlformats.org/officeDocument/2006/relationships/chart" Target="../charts/chart15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9.xml"/><Relationship Id="rId11" Type="http://schemas.openxmlformats.org/officeDocument/2006/relationships/chart" Target="../charts/chart14.xml"/><Relationship Id="rId5" Type="http://schemas.openxmlformats.org/officeDocument/2006/relationships/chart" Target="../charts/chart8.xml"/><Relationship Id="rId10" Type="http://schemas.openxmlformats.org/officeDocument/2006/relationships/chart" Target="../charts/chart13.xml"/><Relationship Id="rId4" Type="http://schemas.openxmlformats.org/officeDocument/2006/relationships/chart" Target="../charts/chart7.xml"/><Relationship Id="rId9" Type="http://schemas.openxmlformats.org/officeDocument/2006/relationships/chart" Target="../charts/chart1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1936" y="596370"/>
            <a:ext cx="3472819" cy="2166994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903664" y="589058"/>
            <a:ext cx="6123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 dpi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213509" y="2412475"/>
            <a:ext cx="11820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RV2:</a:t>
            </a:r>
            <a:r>
              <a:rPr kumimoji="0" lang="en-US" sz="1200" b="1" i="1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FP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818922" y="2412475"/>
            <a:ext cx="14008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RV2:</a:t>
            </a:r>
            <a:r>
              <a:rPr kumimoji="0" lang="en-US" sz="1200" b="1" i="1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FDX1</a:t>
            </a:r>
          </a:p>
        </p:txBody>
      </p:sp>
      <p:graphicFrame>
        <p:nvGraphicFramePr>
          <p:cNvPr id="18" name="Chart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81414935"/>
              </p:ext>
            </p:extLst>
          </p:nvPr>
        </p:nvGraphicFramePr>
        <p:xfrm>
          <a:off x="4796792" y="2933793"/>
          <a:ext cx="3264568" cy="21990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9" name="TextBox 18"/>
          <p:cNvSpPr txBox="1"/>
          <p:nvPr/>
        </p:nvSpPr>
        <p:spPr>
          <a:xfrm>
            <a:off x="5626340" y="4719592"/>
            <a:ext cx="208051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RV2:</a:t>
            </a:r>
            <a:r>
              <a:rPr kumimoji="0" lang="en-US" sz="10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FP</a:t>
            </a: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      TRV2:</a:t>
            </a:r>
            <a:r>
              <a:rPr kumimoji="0" lang="en-US" sz="10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bMFDX1</a:t>
            </a:r>
          </a:p>
        </p:txBody>
      </p:sp>
      <p:sp>
        <p:nvSpPr>
          <p:cNvPr id="7" name="Rectangle 6"/>
          <p:cNvSpPr/>
          <p:nvPr/>
        </p:nvSpPr>
        <p:spPr>
          <a:xfrm>
            <a:off x="717315" y="5059020"/>
            <a:ext cx="10873107" cy="30552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</a:t>
            </a:r>
            <a:r>
              <a:rPr kumimoji="0" lang="en-US" sz="12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bMFDX1-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lenced plants are more susceptible to infection by the nonhost pathogen </a:t>
            </a:r>
            <a:r>
              <a:rPr kumimoji="0" lang="en-US" sz="12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 </a:t>
            </a:r>
            <a:r>
              <a:rPr kumimoji="0" lang="en-US" sz="1200" b="1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yringae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v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kumimoji="0" lang="en-US" sz="12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omato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1 than the control. </a:t>
            </a:r>
            <a:endParaRPr kumimoji="0" 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just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kumimoji="0" lang="en-US" sz="12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FPuv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labeled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 </a:t>
            </a:r>
            <a:r>
              <a:rPr kumimoji="0" lang="en-US" sz="12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yringae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v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omato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1 accumulation in TRV2: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FDX1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eaves compared to unsilenced control TRV2: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FP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eaves under UV light. A needleless syringe was used to infiltrate the 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axial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ide of leaves from 6-week-old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. </a:t>
            </a:r>
            <a:r>
              <a:rPr kumimoji="0" lang="en-US" sz="12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enthamiana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lants with </a:t>
            </a:r>
            <a:r>
              <a:rPr kumimoji="0" lang="en-US" sz="12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FPuv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ressing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 </a:t>
            </a:r>
            <a:r>
              <a:rPr kumimoji="0" lang="en-US" sz="12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yringae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v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omato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1 at 8 x 10</a:t>
            </a:r>
            <a:r>
              <a:rPr kumimoji="0" lang="en-US" sz="12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FU/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L.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hotographs were taken 2 days after infection (2 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i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endParaRPr kumimoji="0" 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lvl="0" algn="just">
              <a:lnSpc>
                <a:spcPct val="107000"/>
              </a:lnSpc>
              <a:spcAft>
                <a:spcPts val="800"/>
              </a:spcAft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Quantification of nonhost pathogen multiplication demonstrates a significant increase in bacterial multiplication for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bMFDX1-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lenced plants compared to the control. The underside of leaves were infiltrated with a needleless syringe containing bacterial solution at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8 x 10</a:t>
            </a:r>
            <a:r>
              <a:rPr kumimoji="0" lang="en-US" sz="12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FU/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L.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istograms represent means of four independent biological replicates. Error bars indicate standard error. Asterisks indicate significant differences according to one-way ANOVA (**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-value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lt; 0.01, ****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-value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lt; 0.0001). </a:t>
            </a:r>
            <a:r>
              <a:rPr lang="en-US" sz="1200" noProof="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i, hours post inoculation; Dpi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days post infection.</a:t>
            </a:r>
          </a:p>
          <a:p>
            <a:pPr marL="0" marR="0" lvl="0" indent="0" algn="just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)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lative gene expression of the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bMFDX1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ene between TRV2: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bMFDX1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TRV2: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FP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control) inoculated plants. Three weeks after inoculating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. </a:t>
            </a:r>
            <a:r>
              <a:rPr kumimoji="0" lang="en-US" sz="1200" b="0" i="1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enthamiana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lants with TRV2 clones, RNA was isolated from leaves and subject to RT-qPCR. The expression level was normalized to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bACTIN1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xpression.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istograms represent means of three biological replicates. Error bars indicate standard error. Asterisk indicates significant differences according to student’s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est (***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-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ue &lt; 0.001). All experiments were repeated two times with similar results.  </a:t>
            </a:r>
            <a:endParaRPr kumimoji="0" 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just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endParaRPr kumimoji="0" 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4586993" y="289150"/>
            <a:ext cx="41959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</a:t>
            </a:r>
            <a:endParaRPr kumimoji="0" 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937852" y="250621"/>
            <a:ext cx="41959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</a:t>
            </a:r>
            <a:endParaRPr kumimoji="0" 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667204" y="2922619"/>
            <a:ext cx="4015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16" name="Chart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2218623"/>
              </p:ext>
            </p:extLst>
          </p:nvPr>
        </p:nvGraphicFramePr>
        <p:xfrm>
          <a:off x="4667204" y="404509"/>
          <a:ext cx="4625975" cy="2736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4" name="TextBox 23"/>
          <p:cNvSpPr txBox="1"/>
          <p:nvPr/>
        </p:nvSpPr>
        <p:spPr>
          <a:xfrm>
            <a:off x="8422858" y="1573537"/>
            <a:ext cx="1237834" cy="5539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RV2:</a:t>
            </a:r>
            <a:r>
              <a:rPr kumimoji="0" lang="en-US" sz="10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FP</a:t>
            </a: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RV2:</a:t>
            </a:r>
            <a:r>
              <a:rPr kumimoji="0" lang="en-US" sz="10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bMFDX1</a:t>
            </a:r>
          </a:p>
        </p:txBody>
      </p:sp>
    </p:spTree>
    <p:extLst>
      <p:ext uri="{BB962C8B-B14F-4D97-AF65-F5344CB8AC3E}">
        <p14:creationId xmlns:p14="http://schemas.microsoft.com/office/powerpoint/2010/main" val="29803890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9AB941A-AA76-4BA9-8037-415DA4E0FFE7}"/>
              </a:ext>
            </a:extLst>
          </p:cNvPr>
          <p:cNvSpPr txBox="1"/>
          <p:nvPr/>
        </p:nvSpPr>
        <p:spPr>
          <a:xfrm>
            <a:off x="3052181" y="771878"/>
            <a:ext cx="18749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fdx1-1 (SALK_033579C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BCE6E8E-595E-40C6-B1E8-8191B4720555}"/>
              </a:ext>
            </a:extLst>
          </p:cNvPr>
          <p:cNvSpPr txBox="1"/>
          <p:nvPr/>
        </p:nvSpPr>
        <p:spPr>
          <a:xfrm>
            <a:off x="577401" y="1857446"/>
            <a:ext cx="574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TG</a:t>
            </a:r>
            <a:endParaRPr kumimoji="0" 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824E636-1ADB-4B3D-8BAA-F37840120051}"/>
              </a:ext>
            </a:extLst>
          </p:cNvPr>
          <p:cNvSpPr txBox="1"/>
          <p:nvPr/>
        </p:nvSpPr>
        <p:spPr>
          <a:xfrm>
            <a:off x="10000403" y="1854008"/>
            <a:ext cx="574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GA</a:t>
            </a:r>
            <a:endParaRPr kumimoji="0" lang="en-US" sz="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2D878A4-65B1-4927-9537-0A497264BEFA}"/>
              </a:ext>
            </a:extLst>
          </p:cNvPr>
          <p:cNvSpPr/>
          <p:nvPr/>
        </p:nvSpPr>
        <p:spPr>
          <a:xfrm flipV="1">
            <a:off x="858467" y="1347677"/>
            <a:ext cx="1161298" cy="36037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89FD73B0-3B49-4130-85F7-505F44AB5893}"/>
              </a:ext>
            </a:extLst>
          </p:cNvPr>
          <p:cNvCxnSpPr/>
          <p:nvPr/>
        </p:nvCxnSpPr>
        <p:spPr>
          <a:xfrm flipV="1">
            <a:off x="3504651" y="1512819"/>
            <a:ext cx="1687223" cy="6845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ctangle 8">
            <a:extLst>
              <a:ext uri="{FF2B5EF4-FFF2-40B4-BE49-F238E27FC236}">
                <a16:creationId xmlns:a16="http://schemas.microsoft.com/office/drawing/2014/main" id="{19DAF0DD-810C-4A23-9D2D-A9DDBF65FE60}"/>
              </a:ext>
            </a:extLst>
          </p:cNvPr>
          <p:cNvSpPr/>
          <p:nvPr/>
        </p:nvSpPr>
        <p:spPr>
          <a:xfrm flipV="1">
            <a:off x="4998651" y="1332633"/>
            <a:ext cx="765691" cy="36037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F0FE7732-DBC5-4797-8F7E-CF87A1F72FDC}"/>
              </a:ext>
            </a:extLst>
          </p:cNvPr>
          <p:cNvSpPr/>
          <p:nvPr/>
        </p:nvSpPr>
        <p:spPr>
          <a:xfrm flipV="1">
            <a:off x="6080746" y="1325788"/>
            <a:ext cx="765691" cy="36037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6B243BA5-DAA7-452C-9295-22D605EFF18F}"/>
              </a:ext>
            </a:extLst>
          </p:cNvPr>
          <p:cNvSpPr/>
          <p:nvPr/>
        </p:nvSpPr>
        <p:spPr>
          <a:xfrm flipV="1">
            <a:off x="7278076" y="1325788"/>
            <a:ext cx="367144" cy="36037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5811578C-9187-48BF-89F8-D7E9B1162696}"/>
              </a:ext>
            </a:extLst>
          </p:cNvPr>
          <p:cNvSpPr/>
          <p:nvPr/>
        </p:nvSpPr>
        <p:spPr>
          <a:xfrm flipV="1">
            <a:off x="8722010" y="1325788"/>
            <a:ext cx="1565876" cy="36037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53C6DB6E-F37A-4D69-987F-65C298DF62D0}"/>
              </a:ext>
            </a:extLst>
          </p:cNvPr>
          <p:cNvCxnSpPr/>
          <p:nvPr/>
        </p:nvCxnSpPr>
        <p:spPr>
          <a:xfrm>
            <a:off x="5051744" y="1505974"/>
            <a:ext cx="558871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4B357699-CF3A-418E-B63F-7D5BA3389923}"/>
              </a:ext>
            </a:extLst>
          </p:cNvPr>
          <p:cNvCxnSpPr/>
          <p:nvPr/>
        </p:nvCxnSpPr>
        <p:spPr>
          <a:xfrm>
            <a:off x="5818432" y="1509182"/>
            <a:ext cx="558871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D14598AD-C17C-4232-ADEB-33ADB88F92B3}"/>
              </a:ext>
            </a:extLst>
          </p:cNvPr>
          <p:cNvCxnSpPr/>
          <p:nvPr/>
        </p:nvCxnSpPr>
        <p:spPr>
          <a:xfrm>
            <a:off x="6744447" y="1499526"/>
            <a:ext cx="558871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0C9CAE0D-607D-4D4D-BCE7-281D9B261D03}"/>
              </a:ext>
            </a:extLst>
          </p:cNvPr>
          <p:cNvCxnSpPr/>
          <p:nvPr/>
        </p:nvCxnSpPr>
        <p:spPr>
          <a:xfrm flipV="1">
            <a:off x="10036957" y="1502391"/>
            <a:ext cx="932598" cy="1042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6352AFC4-0D81-4C3A-91E4-8B4C73EC1A3D}"/>
              </a:ext>
            </a:extLst>
          </p:cNvPr>
          <p:cNvCxnSpPr/>
          <p:nvPr/>
        </p:nvCxnSpPr>
        <p:spPr>
          <a:xfrm>
            <a:off x="864884" y="1648855"/>
            <a:ext cx="0" cy="18441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F384EA48-222A-4E0F-B989-D079024B0E5B}"/>
              </a:ext>
            </a:extLst>
          </p:cNvPr>
          <p:cNvCxnSpPr/>
          <p:nvPr/>
        </p:nvCxnSpPr>
        <p:spPr>
          <a:xfrm>
            <a:off x="10287886" y="1615843"/>
            <a:ext cx="0" cy="18441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78951F46-E51D-4927-83C9-BE06B34A29E4}"/>
              </a:ext>
            </a:extLst>
          </p:cNvPr>
          <p:cNvSpPr txBox="1"/>
          <p:nvPr/>
        </p:nvSpPr>
        <p:spPr>
          <a:xfrm>
            <a:off x="10969555" y="1367904"/>
            <a:ext cx="7751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’ UTR</a:t>
            </a:r>
            <a:endParaRPr kumimoji="0" 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9384396D-C95B-4A90-96C5-39B161432DB2}"/>
              </a:ext>
            </a:extLst>
          </p:cNvPr>
          <p:cNvSpPr/>
          <p:nvPr/>
        </p:nvSpPr>
        <p:spPr>
          <a:xfrm>
            <a:off x="775425" y="683421"/>
            <a:ext cx="41959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</a:t>
            </a:r>
            <a:endParaRPr kumimoji="0" 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1" name="Isosceles Triangle 20">
            <a:extLst>
              <a:ext uri="{FF2B5EF4-FFF2-40B4-BE49-F238E27FC236}">
                <a16:creationId xmlns:a16="http://schemas.microsoft.com/office/drawing/2014/main" id="{316FC4D4-576C-4564-B3CA-00F3795D53ED}"/>
              </a:ext>
            </a:extLst>
          </p:cNvPr>
          <p:cNvSpPr/>
          <p:nvPr/>
        </p:nvSpPr>
        <p:spPr>
          <a:xfrm rot="10800000">
            <a:off x="3111984" y="1027318"/>
            <a:ext cx="595075" cy="294035"/>
          </a:xfrm>
          <a:prstGeom prst="triangle">
            <a:avLst/>
          </a:prstGeom>
          <a:noFill/>
          <a:ln w="222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2E22F843-BDB6-485E-B834-9F80C6EDD655}"/>
              </a:ext>
            </a:extLst>
          </p:cNvPr>
          <p:cNvSpPr/>
          <p:nvPr/>
        </p:nvSpPr>
        <p:spPr>
          <a:xfrm flipV="1">
            <a:off x="2418478" y="1347677"/>
            <a:ext cx="507034" cy="36037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261CF635-014C-4B1D-8A0D-27EDE4CD7A05}"/>
              </a:ext>
            </a:extLst>
          </p:cNvPr>
          <p:cNvSpPr/>
          <p:nvPr/>
        </p:nvSpPr>
        <p:spPr>
          <a:xfrm flipV="1">
            <a:off x="3409522" y="1347677"/>
            <a:ext cx="507034" cy="36037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3A3A3C96-B40E-46FB-B38B-F4E8F76E6222}"/>
              </a:ext>
            </a:extLst>
          </p:cNvPr>
          <p:cNvSpPr/>
          <p:nvPr/>
        </p:nvSpPr>
        <p:spPr>
          <a:xfrm flipV="1">
            <a:off x="7896543" y="1325788"/>
            <a:ext cx="610097" cy="36037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8CF0786C-0850-4CC4-A33E-4C0F0AC2EDE0}"/>
              </a:ext>
            </a:extLst>
          </p:cNvPr>
          <p:cNvCxnSpPr/>
          <p:nvPr/>
        </p:nvCxnSpPr>
        <p:spPr>
          <a:xfrm flipV="1">
            <a:off x="1650652" y="1528232"/>
            <a:ext cx="1088806" cy="1369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848D3508-39B6-4B40-BA30-3D91810ACBBC}"/>
              </a:ext>
            </a:extLst>
          </p:cNvPr>
          <p:cNvCxnSpPr/>
          <p:nvPr/>
        </p:nvCxnSpPr>
        <p:spPr>
          <a:xfrm flipV="1">
            <a:off x="2770211" y="1499129"/>
            <a:ext cx="1088806" cy="1369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4FA65E0-625E-4522-A03D-E60F1227C12C}"/>
              </a:ext>
            </a:extLst>
          </p:cNvPr>
          <p:cNvCxnSpPr/>
          <p:nvPr/>
        </p:nvCxnSpPr>
        <p:spPr>
          <a:xfrm flipV="1">
            <a:off x="7633204" y="1483320"/>
            <a:ext cx="1088806" cy="1369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Isosceles Triangle 27">
            <a:extLst>
              <a:ext uri="{FF2B5EF4-FFF2-40B4-BE49-F238E27FC236}">
                <a16:creationId xmlns:a16="http://schemas.microsoft.com/office/drawing/2014/main" id="{9F0D506B-9AC6-4382-9BB7-B6D68E80BB40}"/>
              </a:ext>
            </a:extLst>
          </p:cNvPr>
          <p:cNvSpPr/>
          <p:nvPr/>
        </p:nvSpPr>
        <p:spPr>
          <a:xfrm rot="10800000">
            <a:off x="2141549" y="1007213"/>
            <a:ext cx="595075" cy="294035"/>
          </a:xfrm>
          <a:prstGeom prst="triangle">
            <a:avLst/>
          </a:prstGeom>
          <a:noFill/>
          <a:ln w="222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3FEDE72-5F39-45A7-9DF9-43221453FFAF}"/>
              </a:ext>
            </a:extLst>
          </p:cNvPr>
          <p:cNvSpPr txBox="1"/>
          <p:nvPr/>
        </p:nvSpPr>
        <p:spPr>
          <a:xfrm>
            <a:off x="1439116" y="771878"/>
            <a:ext cx="17731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kumimoji="0" lang="en-US" sz="10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dx1-2 (SALK_033569)</a:t>
            </a:r>
          </a:p>
        </p:txBody>
      </p:sp>
      <p:graphicFrame>
        <p:nvGraphicFramePr>
          <p:cNvPr id="30" name="Chart 29">
            <a:extLst>
              <a:ext uri="{FF2B5EF4-FFF2-40B4-BE49-F238E27FC236}">
                <a16:creationId xmlns:a16="http://schemas.microsoft.com/office/drawing/2014/main" id="{A3F229EF-4543-4377-A992-853AF585FB3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09228766"/>
              </p:ext>
            </p:extLst>
          </p:nvPr>
        </p:nvGraphicFramePr>
        <p:xfrm>
          <a:off x="595653" y="2552428"/>
          <a:ext cx="2850100" cy="20896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1" name="TextBox 30">
            <a:extLst>
              <a:ext uri="{FF2B5EF4-FFF2-40B4-BE49-F238E27FC236}">
                <a16:creationId xmlns:a16="http://schemas.microsoft.com/office/drawing/2014/main" id="{23A2F4EE-A9C6-422D-AA16-459473EBFEFE}"/>
              </a:ext>
            </a:extLst>
          </p:cNvPr>
          <p:cNvSpPr txBox="1"/>
          <p:nvPr/>
        </p:nvSpPr>
        <p:spPr>
          <a:xfrm>
            <a:off x="1672560" y="4332344"/>
            <a:ext cx="153970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WT            </a:t>
            </a:r>
            <a:r>
              <a:rPr kumimoji="0" lang="en-US" sz="10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fdx1-1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9F908E6-79F4-4536-9956-0E53BFEB7C99}"/>
              </a:ext>
            </a:extLst>
          </p:cNvPr>
          <p:cNvSpPr txBox="1"/>
          <p:nvPr/>
        </p:nvSpPr>
        <p:spPr>
          <a:xfrm>
            <a:off x="1044598" y="4773161"/>
            <a:ext cx="9785999" cy="203716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5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Figure S2.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 </a:t>
            </a:r>
            <a:r>
              <a:rPr kumimoji="0" lang="en-US" sz="1200" b="1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The mfdx1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and </a:t>
            </a:r>
            <a:r>
              <a:rPr kumimoji="0" lang="en-US" sz="1200" b="1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mfdx-2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 mutants have completely abolished, and reduced </a:t>
            </a:r>
            <a:r>
              <a:rPr kumimoji="0" lang="en-US" sz="1200" b="1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MFDX1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expression, respectively compared to the WT.</a:t>
            </a:r>
          </a:p>
          <a:p>
            <a:pPr marL="0" marR="0" lvl="0" indent="0" algn="just" defTabSz="914400" rtl="0" eaLnBrk="1" fontAlgn="auto" latinLnBrk="0" hangingPunct="1">
              <a:lnSpc>
                <a:spcPct val="105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(A) Diagram showing the approximate position of T-DNA insertions in the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mfdx1-1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 (SALK_033579C) and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mfdx1-2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 (SALK_033569) mutants. T-DNA insertion for the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mfdx1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mutant spams the region located between the intronic region and the 4</a:t>
            </a:r>
            <a:r>
              <a:rPr kumimoji="0" lang="en-US" sz="1200" b="0" i="0" u="none" strike="noStrike" kern="1200" cap="none" spc="0" normalizeH="0" baseline="30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th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 exon (exon 2 is not present in AT4g05450.1 gene model), based on flanking sequence analysis. For the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mfdx1-2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 mutation the T-DNA mutation is located on exon 3 (exon 2 is absent from gene model). Exons are displayed as black boxes, introns as dashed lines, and UTR region as a solid line. 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Times New Roman" panose="02020603050405020304" pitchFamily="18" charset="0"/>
              <a:cs typeface="+mn-cs"/>
            </a:endParaRPr>
          </a:p>
          <a:p>
            <a:pPr marL="0" marR="0" lvl="0" indent="0" algn="just" defTabSz="914400" rtl="0" eaLnBrk="1" fontAlgn="auto" latinLnBrk="0" hangingPunct="1">
              <a:lnSpc>
                <a:spcPct val="106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(B) (C) Relative expression of the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AtMFDX1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gene in the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mfdx1-1 </a:t>
            </a:r>
            <a:r>
              <a:rPr kumimoji="0" lang="en-US" sz="1200" b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and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mfdx1-2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mutant lines compared to WT. RNA was isolated from leaves of 5-week-old plants and subject to RT-qPCR. The expression level was normalized to the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AtACT2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gene. Histograms represent means of four biological replicates. Error bars indicate standard error. Asterisk indicates a significant difference compared to WT according to student’s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t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test (*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p-value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&lt; 0.05). All experiments were repeated two times with similar results. 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Times New Roman" panose="02020603050405020304" pitchFamily="18" charset="0"/>
              <a:cs typeface="+mn-cs"/>
            </a:endParaRPr>
          </a:p>
        </p:txBody>
      </p:sp>
      <p:graphicFrame>
        <p:nvGraphicFramePr>
          <p:cNvPr id="32" name="Chart 31">
            <a:extLst>
              <a:ext uri="{FF2B5EF4-FFF2-40B4-BE49-F238E27FC236}">
                <a16:creationId xmlns:a16="http://schemas.microsoft.com/office/drawing/2014/main" id="{7F5AFD70-DDF2-40C5-BA81-908C79BEE09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91858310"/>
              </p:ext>
            </p:extLst>
          </p:nvPr>
        </p:nvGraphicFramePr>
        <p:xfrm>
          <a:off x="3519254" y="2378317"/>
          <a:ext cx="3359150" cy="24320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4" name="TextBox 33">
            <a:extLst>
              <a:ext uri="{FF2B5EF4-FFF2-40B4-BE49-F238E27FC236}">
                <a16:creationId xmlns:a16="http://schemas.microsoft.com/office/drawing/2014/main" id="{327ECB27-11CA-4E9E-95D5-4C7BAE8EFB91}"/>
              </a:ext>
            </a:extLst>
          </p:cNvPr>
          <p:cNvSpPr txBox="1"/>
          <p:nvPr/>
        </p:nvSpPr>
        <p:spPr>
          <a:xfrm>
            <a:off x="4727352" y="4395865"/>
            <a:ext cx="153970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WT            </a:t>
            </a:r>
            <a:r>
              <a:rPr kumimoji="0" lang="en-US" sz="10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fdx1-2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A2E853F9-5D46-4171-8955-3C3E3F9CFF63}"/>
              </a:ext>
            </a:extLst>
          </p:cNvPr>
          <p:cNvSpPr/>
          <p:nvPr/>
        </p:nvSpPr>
        <p:spPr>
          <a:xfrm>
            <a:off x="732768" y="2297417"/>
            <a:ext cx="41959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</a:t>
            </a:r>
            <a:endParaRPr kumimoji="0" 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097AA157-E958-4560-A241-0E65B903B191}"/>
              </a:ext>
            </a:extLst>
          </p:cNvPr>
          <p:cNvSpPr/>
          <p:nvPr/>
        </p:nvSpPr>
        <p:spPr>
          <a:xfrm>
            <a:off x="3636648" y="2289607"/>
            <a:ext cx="41959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</a:t>
            </a:r>
            <a:endParaRPr kumimoji="0" 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310240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9882" y="510316"/>
            <a:ext cx="7270313" cy="2048679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76751" y="0"/>
            <a:ext cx="3196554" cy="6856572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633465" y="202539"/>
            <a:ext cx="35888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</a:t>
            </a:r>
            <a:endParaRPr kumimoji="0" 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6784240" y="202539"/>
            <a:ext cx="35987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</a:t>
            </a:r>
            <a:endParaRPr kumimoji="0" 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633465" y="4019063"/>
            <a:ext cx="4678041" cy="13747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Figure S3. Expression of </a:t>
            </a:r>
            <a:r>
              <a:rPr kumimoji="0" lang="en-US" sz="1200" b="1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AtMFDX1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in different organs in Arabidopsis.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Times New Roman" panose="02020603050405020304" pitchFamily="18" charset="0"/>
              <a:cs typeface="+mn-cs"/>
            </a:endParaRP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ression levels of the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tMFDX1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 from publicly available gene expression data at different developmental stages (A) and organs (B) in Arabidopsis using the 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vestigator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oftware.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96719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6" name="Chart 4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70705186"/>
              </p:ext>
            </p:extLst>
          </p:nvPr>
        </p:nvGraphicFramePr>
        <p:xfrm>
          <a:off x="2811480" y="4693376"/>
          <a:ext cx="3083593" cy="21460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9" name="Chart 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59995284"/>
              </p:ext>
            </p:extLst>
          </p:nvPr>
        </p:nvGraphicFramePr>
        <p:xfrm>
          <a:off x="2772329" y="2665899"/>
          <a:ext cx="3161897" cy="21385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2" name="TextBox 1"/>
          <p:cNvSpPr txBox="1"/>
          <p:nvPr/>
        </p:nvSpPr>
        <p:spPr>
          <a:xfrm rot="16200000">
            <a:off x="-467420" y="1116019"/>
            <a:ext cx="1379620" cy="30712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onductance (µS)</a:t>
            </a:r>
          </a:p>
        </p:txBody>
      </p:sp>
      <p:sp>
        <p:nvSpPr>
          <p:cNvPr id="23" name="TextBox 1"/>
          <p:cNvSpPr txBox="1"/>
          <p:nvPr/>
        </p:nvSpPr>
        <p:spPr>
          <a:xfrm rot="16200000">
            <a:off x="2363114" y="1243072"/>
            <a:ext cx="1379620" cy="30712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onductance (µS)</a:t>
            </a:r>
          </a:p>
        </p:txBody>
      </p:sp>
      <p:sp>
        <p:nvSpPr>
          <p:cNvPr id="24" name="TextBox 1"/>
          <p:cNvSpPr txBox="1"/>
          <p:nvPr/>
        </p:nvSpPr>
        <p:spPr>
          <a:xfrm rot="16200000">
            <a:off x="5067116" y="1196993"/>
            <a:ext cx="1379620" cy="30712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onductance (µS)</a:t>
            </a:r>
          </a:p>
        </p:txBody>
      </p:sp>
      <p:sp>
        <p:nvSpPr>
          <p:cNvPr id="25" name="TextBox 1"/>
          <p:cNvSpPr txBox="1"/>
          <p:nvPr/>
        </p:nvSpPr>
        <p:spPr>
          <a:xfrm rot="16200000">
            <a:off x="8067188" y="1252030"/>
            <a:ext cx="1379620" cy="30712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onductance (µS)</a:t>
            </a:r>
          </a:p>
        </p:txBody>
      </p:sp>
      <p:sp>
        <p:nvSpPr>
          <p:cNvPr id="26" name="TextBox 1"/>
          <p:cNvSpPr txBox="1"/>
          <p:nvPr/>
        </p:nvSpPr>
        <p:spPr>
          <a:xfrm rot="16200000">
            <a:off x="-503571" y="3464903"/>
            <a:ext cx="1379620" cy="30712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onductance (µS)</a:t>
            </a:r>
          </a:p>
        </p:txBody>
      </p:sp>
      <p:sp>
        <p:nvSpPr>
          <p:cNvPr id="27" name="TextBox 1"/>
          <p:cNvSpPr txBox="1"/>
          <p:nvPr/>
        </p:nvSpPr>
        <p:spPr>
          <a:xfrm rot="16200000">
            <a:off x="2236082" y="3356200"/>
            <a:ext cx="1379620" cy="30712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onductance (µS)</a:t>
            </a:r>
          </a:p>
        </p:txBody>
      </p:sp>
      <p:sp>
        <p:nvSpPr>
          <p:cNvPr id="28" name="TextBox 1"/>
          <p:cNvSpPr txBox="1"/>
          <p:nvPr/>
        </p:nvSpPr>
        <p:spPr>
          <a:xfrm rot="16200000">
            <a:off x="5190936" y="3457852"/>
            <a:ext cx="1379620" cy="30712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onductance (µS)</a:t>
            </a:r>
          </a:p>
        </p:txBody>
      </p:sp>
      <p:sp>
        <p:nvSpPr>
          <p:cNvPr id="29" name="TextBox 1"/>
          <p:cNvSpPr txBox="1"/>
          <p:nvPr/>
        </p:nvSpPr>
        <p:spPr>
          <a:xfrm rot="16200000">
            <a:off x="8082499" y="3464904"/>
            <a:ext cx="1379620" cy="30712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onductance (µS)</a:t>
            </a:r>
          </a:p>
        </p:txBody>
      </p:sp>
      <p:sp>
        <p:nvSpPr>
          <p:cNvPr id="30" name="TextBox 1"/>
          <p:cNvSpPr txBox="1"/>
          <p:nvPr/>
        </p:nvSpPr>
        <p:spPr>
          <a:xfrm rot="16200000">
            <a:off x="-350009" y="5564572"/>
            <a:ext cx="1379620" cy="30712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onductance (µS)</a:t>
            </a:r>
          </a:p>
        </p:txBody>
      </p:sp>
      <p:sp>
        <p:nvSpPr>
          <p:cNvPr id="31" name="TextBox 1"/>
          <p:cNvSpPr txBox="1"/>
          <p:nvPr/>
        </p:nvSpPr>
        <p:spPr>
          <a:xfrm rot="16200000">
            <a:off x="2312386" y="5494746"/>
            <a:ext cx="1379620" cy="30712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onductance (µS)</a:t>
            </a:r>
          </a:p>
        </p:txBody>
      </p:sp>
      <p:sp>
        <p:nvSpPr>
          <p:cNvPr id="32" name="TextBox 1"/>
          <p:cNvSpPr txBox="1"/>
          <p:nvPr/>
        </p:nvSpPr>
        <p:spPr>
          <a:xfrm rot="16200000">
            <a:off x="5075229" y="5713587"/>
            <a:ext cx="1379620" cy="30712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onductance (µS)</a:t>
            </a:r>
          </a:p>
        </p:txBody>
      </p:sp>
      <p:sp>
        <p:nvSpPr>
          <p:cNvPr id="33" name="Rectangle 32"/>
          <p:cNvSpPr/>
          <p:nvPr/>
        </p:nvSpPr>
        <p:spPr>
          <a:xfrm>
            <a:off x="0" y="82287"/>
            <a:ext cx="35888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</a:t>
            </a:r>
            <a:endParaRPr kumimoji="0" 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aphicFrame>
        <p:nvGraphicFramePr>
          <p:cNvPr id="34" name="Chart 3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72546218"/>
              </p:ext>
            </p:extLst>
          </p:nvPr>
        </p:nvGraphicFramePr>
        <p:xfrm>
          <a:off x="-24880" y="234369"/>
          <a:ext cx="3298044" cy="21547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5" name="Chart 3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35130784"/>
              </p:ext>
            </p:extLst>
          </p:nvPr>
        </p:nvGraphicFramePr>
        <p:xfrm>
          <a:off x="2737685" y="171120"/>
          <a:ext cx="3019241" cy="23405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6" name="Chart 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97397655"/>
              </p:ext>
            </p:extLst>
          </p:nvPr>
        </p:nvGraphicFramePr>
        <p:xfrm>
          <a:off x="5696729" y="289929"/>
          <a:ext cx="2802114" cy="21212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7" name="Chart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0231711"/>
              </p:ext>
            </p:extLst>
          </p:nvPr>
        </p:nvGraphicFramePr>
        <p:xfrm>
          <a:off x="8603435" y="446148"/>
          <a:ext cx="2784640" cy="22018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38" name="Chart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98272712"/>
              </p:ext>
            </p:extLst>
          </p:nvPr>
        </p:nvGraphicFramePr>
        <p:xfrm>
          <a:off x="316510" y="2663757"/>
          <a:ext cx="2717669" cy="21308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41" name="Chart 4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35864391"/>
              </p:ext>
            </p:extLst>
          </p:nvPr>
        </p:nvGraphicFramePr>
        <p:xfrm>
          <a:off x="8629975" y="2792430"/>
          <a:ext cx="2959357" cy="19449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42" name="Chart 4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75115008"/>
              </p:ext>
            </p:extLst>
          </p:nvPr>
        </p:nvGraphicFramePr>
        <p:xfrm>
          <a:off x="389468" y="4790576"/>
          <a:ext cx="2654237" cy="19471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44" name="Chart 4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5803673"/>
              </p:ext>
            </p:extLst>
          </p:nvPr>
        </p:nvGraphicFramePr>
        <p:xfrm>
          <a:off x="5821251" y="4938432"/>
          <a:ext cx="2553069" cy="20323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45" name="Chart 4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83349832"/>
              </p:ext>
            </p:extLst>
          </p:nvPr>
        </p:nvGraphicFramePr>
        <p:xfrm>
          <a:off x="5647677" y="2707056"/>
          <a:ext cx="2955758" cy="20564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</p:spTree>
    <p:extLst>
      <p:ext uri="{BB962C8B-B14F-4D97-AF65-F5344CB8AC3E}">
        <p14:creationId xmlns:p14="http://schemas.microsoft.com/office/powerpoint/2010/main" val="2057615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39979" y="1268274"/>
            <a:ext cx="6096000" cy="2152512"/>
          </a:xfrm>
          <a:prstGeom prst="rect">
            <a:avLst/>
          </a:prstGeom>
        </p:spPr>
        <p:txBody>
          <a:bodyPr>
            <a:spAutoFit/>
          </a:bodyPr>
          <a:lstStyle/>
          <a:p>
            <a:pPr lvl="0" algn="just">
              <a:lnSpc>
                <a:spcPct val="106000"/>
              </a:lnSpc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Figure S4. Nutrient accumulation between the </a:t>
            </a:r>
            <a:r>
              <a:rPr lang="en-US" sz="1200" b="1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mfdx1-1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mutant and</a:t>
            </a:r>
            <a:r>
              <a:rPr lang="en-US" sz="1200" b="1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WT plants upon </a:t>
            </a:r>
            <a:r>
              <a:rPr lang="en-US" sz="1200" b="1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P. </a:t>
            </a:r>
            <a:r>
              <a:rPr lang="en-US" sz="1200" b="1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yringae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pv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. </a:t>
            </a:r>
            <a:r>
              <a:rPr lang="en-US" sz="1200" b="1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tomato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DC3000 infection. </a:t>
            </a:r>
            <a:endParaRPr lang="en-US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lvl="0" algn="just">
              <a:lnSpc>
                <a:spcPct val="106000"/>
              </a:lnSpc>
              <a:spcAft>
                <a:spcPts val="800"/>
              </a:spcAft>
            </a:pP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The aerial part (leaf and stem) of 5-week-old Arabidopsis seedlings was collected from four plants (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n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= 4) between the WT and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mfdx1-1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mutant at different time points (0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hpi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, 1 dpi and 3 dpi) upon flood-inoculation with host pathogen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P.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yringae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pv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.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tomato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DC3000 (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8 x 10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4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CFU/mL). Metabolites from these samples were extracted and levels of several essential nutrients (cations and anions) were monitored by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ion chromatography. Histograms represent means of four biological replicates. Error bars indicate standard error. Asterisks indicate significant differences according to student’s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t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test (*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p-value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&lt; 0.05, **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p-value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&lt; 0.01). hpi, hours post infection; dpi, days post infection. </a:t>
            </a:r>
            <a:endParaRPr lang="en-US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42560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589</TotalTime>
  <Words>848</Words>
  <Application>Microsoft Office PowerPoint</Application>
  <PresentationFormat>Widescreen</PresentationFormat>
  <Paragraphs>7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oble Foundait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onseca, Jose</dc:creator>
  <cp:lastModifiedBy>jose fonseca</cp:lastModifiedBy>
  <cp:revision>104</cp:revision>
  <dcterms:created xsi:type="dcterms:W3CDTF">2020-09-30T19:46:12Z</dcterms:created>
  <dcterms:modified xsi:type="dcterms:W3CDTF">2021-06-08T23:01:35Z</dcterms:modified>
</cp:coreProperties>
</file>